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30" d="100"/>
          <a:sy n="130" d="100"/>
        </p:scale>
        <p:origin x="2004" y="-3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A MARIA VAIRA" userId="S::annamaria.vaira@cnr.it::07571697-e96e-4085-b98c-c13b660e5005" providerId="AD" clId="Web-{73FFF247-DB7F-29F7-314A-75F3601D551C}"/>
    <pc:docChg chg="modSld">
      <pc:chgData name="ANNA MARIA VAIRA" userId="S::annamaria.vaira@cnr.it::07571697-e96e-4085-b98c-c13b660e5005" providerId="AD" clId="Web-{73FFF247-DB7F-29F7-314A-75F3601D551C}" dt="2025-02-10T15:15:57.759" v="10" actId="20577"/>
      <pc:docMkLst>
        <pc:docMk/>
      </pc:docMkLst>
      <pc:sldChg chg="modSp">
        <pc:chgData name="ANNA MARIA VAIRA" userId="S::annamaria.vaira@cnr.it::07571697-e96e-4085-b98c-c13b660e5005" providerId="AD" clId="Web-{73FFF247-DB7F-29F7-314A-75F3601D551C}" dt="2025-02-10T15:15:57.759" v="10" actId="20577"/>
        <pc:sldMkLst>
          <pc:docMk/>
          <pc:sldMk cId="3789454844" sldId="256"/>
        </pc:sldMkLst>
        <pc:spChg chg="mod">
          <ac:chgData name="ANNA MARIA VAIRA" userId="S::annamaria.vaira@cnr.it::07571697-e96e-4085-b98c-c13b660e5005" providerId="AD" clId="Web-{73FFF247-DB7F-29F7-314A-75F3601D551C}" dt="2025-02-10T15:15:25.461" v="6" actId="20577"/>
          <ac:spMkLst>
            <pc:docMk/>
            <pc:sldMk cId="3789454844" sldId="256"/>
            <ac:spMk id="5" creationId="{D0862031-F6F8-CD8A-1223-FCD978ADAEE8}"/>
          </ac:spMkLst>
        </pc:spChg>
        <pc:spChg chg="mod">
          <ac:chgData name="ANNA MARIA VAIRA" userId="S::annamaria.vaira@cnr.it::07571697-e96e-4085-b98c-c13b660e5005" providerId="AD" clId="Web-{73FFF247-DB7F-29F7-314A-75F3601D551C}" dt="2025-02-10T15:15:57.759" v="10" actId="20577"/>
          <ac:spMkLst>
            <pc:docMk/>
            <pc:sldMk cId="3789454844" sldId="256"/>
            <ac:spMk id="24" creationId="{C7C5D0FA-9335-DBF2-E6BA-33C3F07EF4E0}"/>
          </ac:spMkLst>
        </pc:spChg>
        <pc:grpChg chg="mod">
          <ac:chgData name="ANNA MARIA VAIRA" userId="S::annamaria.vaira@cnr.it::07571697-e96e-4085-b98c-c13b660e5005" providerId="AD" clId="Web-{73FFF247-DB7F-29F7-314A-75F3601D551C}" dt="2025-02-10T15:15:49.446" v="8" actId="1076"/>
          <ac:grpSpMkLst>
            <pc:docMk/>
            <pc:sldMk cId="3789454844" sldId="256"/>
            <ac:grpSpMk id="72" creationId="{6B52C896-422F-8B51-6CCB-8DBA20B476B9}"/>
          </ac:grpSpMkLst>
        </pc:grpChg>
      </pc:sldChg>
    </pc:docChg>
  </pc:docChgLst>
  <pc:docChgLst>
    <pc:chgData name="ANNA MARIA VAIRA" userId="S::annamaria.vaira@cnr.it::07571697-e96e-4085-b98c-c13b660e5005" providerId="AD" clId="Web-{06518D02-5A02-518F-90F6-983136BE11E4}"/>
    <pc:docChg chg="modSld">
      <pc:chgData name="ANNA MARIA VAIRA" userId="S::annamaria.vaira@cnr.it::07571697-e96e-4085-b98c-c13b660e5005" providerId="AD" clId="Web-{06518D02-5A02-518F-90F6-983136BE11E4}" dt="2025-02-10T15:13:57.510" v="15" actId="20577"/>
      <pc:docMkLst>
        <pc:docMk/>
      </pc:docMkLst>
      <pc:sldChg chg="modSp">
        <pc:chgData name="ANNA MARIA VAIRA" userId="S::annamaria.vaira@cnr.it::07571697-e96e-4085-b98c-c13b660e5005" providerId="AD" clId="Web-{06518D02-5A02-518F-90F6-983136BE11E4}" dt="2025-02-10T15:13:57.510" v="15" actId="20577"/>
        <pc:sldMkLst>
          <pc:docMk/>
          <pc:sldMk cId="3789454844" sldId="256"/>
        </pc:sldMkLst>
        <pc:spChg chg="mod">
          <ac:chgData name="ANNA MARIA VAIRA" userId="S::annamaria.vaira@cnr.it::07571697-e96e-4085-b98c-c13b660e5005" providerId="AD" clId="Web-{06518D02-5A02-518F-90F6-983136BE11E4}" dt="2025-02-10T15:13:57.510" v="15" actId="20577"/>
          <ac:spMkLst>
            <pc:docMk/>
            <pc:sldMk cId="3789454844" sldId="256"/>
            <ac:spMk id="5" creationId="{D0862031-F6F8-CD8A-1223-FCD978ADAEE8}"/>
          </ac:spMkLst>
        </pc:spChg>
      </pc:sldChg>
    </pc:docChg>
  </pc:docChgLst>
  <pc:docChgLst>
    <pc:chgData name="LAURA MIOZZI" userId="c8ec988e-57c5-4106-9762-eb9b651ca5e9" providerId="ADAL" clId="{2987604F-A8AA-42F5-AABA-D7B103F0407B}"/>
    <pc:docChg chg="undo custSel addSld delSld modSld">
      <pc:chgData name="LAURA MIOZZI" userId="c8ec988e-57c5-4106-9762-eb9b651ca5e9" providerId="ADAL" clId="{2987604F-A8AA-42F5-AABA-D7B103F0407B}" dt="2024-12-17T15:54:55.886" v="1302" actId="14100"/>
      <pc:docMkLst>
        <pc:docMk/>
      </pc:docMkLst>
      <pc:sldChg chg="addSp delSp modSp mod">
        <pc:chgData name="LAURA MIOZZI" userId="c8ec988e-57c5-4106-9762-eb9b651ca5e9" providerId="ADAL" clId="{2987604F-A8AA-42F5-AABA-D7B103F0407B}" dt="2024-12-17T15:54:55.886" v="1302" actId="14100"/>
        <pc:sldMkLst>
          <pc:docMk/>
          <pc:sldMk cId="3789454844" sldId="256"/>
        </pc:sldMkLst>
        <pc:spChg chg="add mod">
          <ac:chgData name="LAURA MIOZZI" userId="c8ec988e-57c5-4106-9762-eb9b651ca5e9" providerId="ADAL" clId="{2987604F-A8AA-42F5-AABA-D7B103F0407B}" dt="2024-12-17T15:54:55.886" v="1302" actId="14100"/>
          <ac:spMkLst>
            <pc:docMk/>
            <pc:sldMk cId="3789454844" sldId="256"/>
            <ac:spMk id="5" creationId="{D0862031-F6F8-CD8A-1223-FCD978ADAEE8}"/>
          </ac:spMkLst>
        </pc:spChg>
        <pc:spChg chg="add mod topLvl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6" creationId="{2B836896-7C62-3094-B580-1DF7286AB177}"/>
          </ac:spMkLst>
        </pc:spChg>
        <pc:spChg chg="add mod topLvl">
          <ac:chgData name="LAURA MIOZZI" userId="c8ec988e-57c5-4106-9762-eb9b651ca5e9" providerId="ADAL" clId="{2987604F-A8AA-42F5-AABA-D7B103F0407B}" dt="2024-12-17T15:53:37.943" v="1246" actId="20577"/>
          <ac:spMkLst>
            <pc:docMk/>
            <pc:sldMk cId="3789454844" sldId="256"/>
            <ac:spMk id="8" creationId="{7A9EAF35-B2A2-6828-CD2A-3552D833A1FA}"/>
          </ac:spMkLst>
        </pc:spChg>
        <pc:spChg chg="add mod topLvl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11" creationId="{C37BDE1F-9D13-F73D-9AC5-950137E54FB4}"/>
          </ac:spMkLst>
        </pc:spChg>
        <pc:spChg chg="add mod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14" creationId="{93371108-6244-38F4-80DD-0CD5D2685E83}"/>
          </ac:spMkLst>
        </pc:spChg>
        <pc:spChg chg="add mod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15" creationId="{8B0B045A-D0D3-FF5B-6988-E5AFD1B127A9}"/>
          </ac:spMkLst>
        </pc:spChg>
        <pc:spChg chg="add mod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17" creationId="{E2C04B19-62FE-8D50-8ED8-7BEE96168DDB}"/>
          </ac:spMkLst>
        </pc:spChg>
        <pc:spChg chg="add mod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18" creationId="{12D71220-06A6-9996-0869-C5A0A56A817A}"/>
          </ac:spMkLst>
        </pc:spChg>
        <pc:spChg chg="add mod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21" creationId="{41AE4D69-D33C-F2BD-FD39-AD137649A941}"/>
          </ac:spMkLst>
        </pc:spChg>
        <pc:spChg chg="add mod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22" creationId="{391C00AD-AF93-068E-48F4-AB03CA185C55}"/>
          </ac:spMkLst>
        </pc:spChg>
        <pc:spChg chg="add mod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23" creationId="{43A9CC97-5055-52A7-3EAA-73E81C13128E}"/>
          </ac:spMkLst>
        </pc:spChg>
        <pc:spChg chg="add mod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24" creationId="{C7C5D0FA-9335-DBF2-E6BA-33C3F07EF4E0}"/>
          </ac:spMkLst>
        </pc:spChg>
        <pc:spChg chg="add del mod">
          <ac:chgData name="LAURA MIOZZI" userId="c8ec988e-57c5-4106-9762-eb9b651ca5e9" providerId="ADAL" clId="{2987604F-A8AA-42F5-AABA-D7B103F0407B}" dt="2024-12-17T14:57:47.500" v="418" actId="478"/>
          <ac:spMkLst>
            <pc:docMk/>
            <pc:sldMk cId="3789454844" sldId="256"/>
            <ac:spMk id="25" creationId="{E1778E22-7A12-1B98-CC22-C1F013B1A3D3}"/>
          </ac:spMkLst>
        </pc:spChg>
        <pc:spChg chg="add mod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26" creationId="{596CE538-C088-6F4D-3F21-6DF392D691F3}"/>
          </ac:spMkLst>
        </pc:spChg>
        <pc:spChg chg="add mod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28" creationId="{6D3BEDF8-325D-210C-7203-D7EB3F582210}"/>
          </ac:spMkLst>
        </pc:spChg>
        <pc:spChg chg="add mod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29" creationId="{02391B16-1323-DD6C-E369-E23F51DE6A5A}"/>
          </ac:spMkLst>
        </pc:spChg>
        <pc:spChg chg="mod">
          <ac:chgData name="LAURA MIOZZI" userId="c8ec988e-57c5-4106-9762-eb9b651ca5e9" providerId="ADAL" clId="{2987604F-A8AA-42F5-AABA-D7B103F0407B}" dt="2024-12-17T15:03:43.080" v="531"/>
          <ac:spMkLst>
            <pc:docMk/>
            <pc:sldMk cId="3789454844" sldId="256"/>
            <ac:spMk id="34" creationId="{6D3BEDF8-325D-210C-7203-D7EB3F582210}"/>
          </ac:spMkLst>
        </pc:spChg>
        <pc:spChg chg="mod">
          <ac:chgData name="LAURA MIOZZI" userId="c8ec988e-57c5-4106-9762-eb9b651ca5e9" providerId="ADAL" clId="{2987604F-A8AA-42F5-AABA-D7B103F0407B}" dt="2024-12-17T15:03:43.080" v="531"/>
          <ac:spMkLst>
            <pc:docMk/>
            <pc:sldMk cId="3789454844" sldId="256"/>
            <ac:spMk id="35" creationId="{02391B16-1323-DD6C-E369-E23F51DE6A5A}"/>
          </ac:spMkLst>
        </pc:spChg>
        <pc:spChg chg="add mod ord topLvl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39" creationId="{9227031A-962F-0E90-BABA-264231932C86}"/>
          </ac:spMkLst>
        </pc:spChg>
        <pc:spChg chg="add mod topLvl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40" creationId="{F48F6D8C-F0A1-6872-58F7-ED1498FD9FBE}"/>
          </ac:spMkLst>
        </pc:spChg>
        <pc:spChg chg="mod">
          <ac:chgData name="LAURA MIOZZI" userId="c8ec988e-57c5-4106-9762-eb9b651ca5e9" providerId="ADAL" clId="{2987604F-A8AA-42F5-AABA-D7B103F0407B}" dt="2024-12-17T15:18:44.199" v="686"/>
          <ac:spMkLst>
            <pc:docMk/>
            <pc:sldMk cId="3789454844" sldId="256"/>
            <ac:spMk id="50" creationId="{33091CCE-1904-0611-D0BF-57BFB4820A66}"/>
          </ac:spMkLst>
        </pc:spChg>
        <pc:spChg chg="mod">
          <ac:chgData name="LAURA MIOZZI" userId="c8ec988e-57c5-4106-9762-eb9b651ca5e9" providerId="ADAL" clId="{2987604F-A8AA-42F5-AABA-D7B103F0407B}" dt="2024-12-17T15:18:44.199" v="686"/>
          <ac:spMkLst>
            <pc:docMk/>
            <pc:sldMk cId="3789454844" sldId="256"/>
            <ac:spMk id="52" creationId="{F6F2BDBB-91D1-E886-A57C-2C7ADC6C14D7}"/>
          </ac:spMkLst>
        </pc:spChg>
        <pc:spChg chg="mod">
          <ac:chgData name="LAURA MIOZZI" userId="c8ec988e-57c5-4106-9762-eb9b651ca5e9" providerId="ADAL" clId="{2987604F-A8AA-42F5-AABA-D7B103F0407B}" dt="2024-12-17T15:18:44.199" v="686"/>
          <ac:spMkLst>
            <pc:docMk/>
            <pc:sldMk cId="3789454844" sldId="256"/>
            <ac:spMk id="53" creationId="{15D269B3-A942-56AD-0772-B2D2F50EAD10}"/>
          </ac:spMkLst>
        </pc:spChg>
        <pc:spChg chg="add mod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54" creationId="{277BEDEB-4A42-9384-7EC4-3A06B9185139}"/>
          </ac:spMkLst>
        </pc:spChg>
        <pc:spChg chg="add mod">
          <ac:chgData name="LAURA MIOZZI" userId="c8ec988e-57c5-4106-9762-eb9b651ca5e9" providerId="ADAL" clId="{2987604F-A8AA-42F5-AABA-D7B103F0407B}" dt="2024-12-17T15:52:58.221" v="1235" actId="2711"/>
          <ac:spMkLst>
            <pc:docMk/>
            <pc:sldMk cId="3789454844" sldId="256"/>
            <ac:spMk id="57" creationId="{91B1745E-8787-C3D0-E254-AEAAC50598A0}"/>
          </ac:spMkLst>
        </pc:spChg>
        <pc:spChg chg="add mod">
          <ac:chgData name="LAURA MIOZZI" userId="c8ec988e-57c5-4106-9762-eb9b651ca5e9" providerId="ADAL" clId="{2987604F-A8AA-42F5-AABA-D7B103F0407B}" dt="2024-12-17T15:53:31.191" v="1242" actId="20577"/>
          <ac:spMkLst>
            <pc:docMk/>
            <pc:sldMk cId="3789454844" sldId="256"/>
            <ac:spMk id="70" creationId="{F25B2E67-6A62-8B35-4906-8D758DC91A41}"/>
          </ac:spMkLst>
        </pc:spChg>
        <pc:grpChg chg="add del mod topLvl">
          <ac:chgData name="LAURA MIOZZI" userId="c8ec988e-57c5-4106-9762-eb9b651ca5e9" providerId="ADAL" clId="{2987604F-A8AA-42F5-AABA-D7B103F0407B}" dt="2024-12-17T15:39:56.869" v="833" actId="165"/>
          <ac:grpSpMkLst>
            <pc:docMk/>
            <pc:sldMk cId="3789454844" sldId="256"/>
            <ac:grpSpMk id="9" creationId="{82E585D5-B7CC-69C5-3FF5-6085F60318A2}"/>
          </ac:grpSpMkLst>
        </pc:grpChg>
        <pc:grpChg chg="add del mod">
          <ac:chgData name="LAURA MIOZZI" userId="c8ec988e-57c5-4106-9762-eb9b651ca5e9" providerId="ADAL" clId="{2987604F-A8AA-42F5-AABA-D7B103F0407B}" dt="2024-12-17T15:39:49.269" v="832" actId="165"/>
          <ac:grpSpMkLst>
            <pc:docMk/>
            <pc:sldMk cId="3789454844" sldId="256"/>
            <ac:grpSpMk id="12" creationId="{C3A54E98-EE60-3A97-619D-5B4522C60A90}"/>
          </ac:grpSpMkLst>
        </pc:grpChg>
        <pc:grpChg chg="add del mod">
          <ac:chgData name="LAURA MIOZZI" userId="c8ec988e-57c5-4106-9762-eb9b651ca5e9" providerId="ADAL" clId="{2987604F-A8AA-42F5-AABA-D7B103F0407B}" dt="2024-12-17T15:49:41.860" v="1169" actId="164"/>
          <ac:grpSpMkLst>
            <pc:docMk/>
            <pc:sldMk cId="3789454844" sldId="256"/>
            <ac:grpSpMk id="30" creationId="{ADB3B578-28F4-DA08-0841-3E7C0BA62E6A}"/>
          </ac:grpSpMkLst>
        </pc:grpChg>
        <pc:grpChg chg="add mod">
          <ac:chgData name="LAURA MIOZZI" userId="c8ec988e-57c5-4106-9762-eb9b651ca5e9" providerId="ADAL" clId="{2987604F-A8AA-42F5-AABA-D7B103F0407B}" dt="2024-12-17T15:03:43.080" v="531"/>
          <ac:grpSpMkLst>
            <pc:docMk/>
            <pc:sldMk cId="3789454844" sldId="256"/>
            <ac:grpSpMk id="32" creationId="{ADB3B578-28F4-DA08-0841-3E7C0BA62E6A}"/>
          </ac:grpSpMkLst>
        </pc:grpChg>
        <pc:grpChg chg="add mod">
          <ac:chgData name="LAURA MIOZZI" userId="c8ec988e-57c5-4106-9762-eb9b651ca5e9" providerId="ADAL" clId="{2987604F-A8AA-42F5-AABA-D7B103F0407B}" dt="2024-12-17T15:53:49.714" v="1247" actId="164"/>
          <ac:grpSpMkLst>
            <pc:docMk/>
            <pc:sldMk cId="3789454844" sldId="256"/>
            <ac:grpSpMk id="36" creationId="{32A559C6-3781-4D7C-88C6-2FEDBAFB4544}"/>
          </ac:grpSpMkLst>
        </pc:grpChg>
        <pc:grpChg chg="add mod">
          <ac:chgData name="LAURA MIOZZI" userId="c8ec988e-57c5-4106-9762-eb9b651ca5e9" providerId="ADAL" clId="{2987604F-A8AA-42F5-AABA-D7B103F0407B}" dt="2024-12-17T15:53:49.714" v="1247" actId="164"/>
          <ac:grpSpMkLst>
            <pc:docMk/>
            <pc:sldMk cId="3789454844" sldId="256"/>
            <ac:grpSpMk id="37" creationId="{59487048-F850-32BC-977A-6490B4BC9CAD}"/>
          </ac:grpSpMkLst>
        </pc:grpChg>
        <pc:grpChg chg="add del mod">
          <ac:chgData name="LAURA MIOZZI" userId="c8ec988e-57c5-4106-9762-eb9b651ca5e9" providerId="ADAL" clId="{2987604F-A8AA-42F5-AABA-D7B103F0407B}" dt="2024-12-17T15:45:05.730" v="1097" actId="165"/>
          <ac:grpSpMkLst>
            <pc:docMk/>
            <pc:sldMk cId="3789454844" sldId="256"/>
            <ac:grpSpMk id="41" creationId="{B80CCE41-374C-1D67-6325-8DDD2D43AA6B}"/>
          </ac:grpSpMkLst>
        </pc:grpChg>
        <pc:grpChg chg="add del mod">
          <ac:chgData name="LAURA MIOZZI" userId="c8ec988e-57c5-4106-9762-eb9b651ca5e9" providerId="ADAL" clId="{2987604F-A8AA-42F5-AABA-D7B103F0407B}" dt="2024-12-17T15:37:51.865" v="816" actId="478"/>
          <ac:grpSpMkLst>
            <pc:docMk/>
            <pc:sldMk cId="3789454844" sldId="256"/>
            <ac:grpSpMk id="42" creationId="{5B6F91E6-9AF1-4817-9774-994AB326E534}"/>
          </ac:grpSpMkLst>
        </pc:grpChg>
        <pc:grpChg chg="add del mod">
          <ac:chgData name="LAURA MIOZZI" userId="c8ec988e-57c5-4106-9762-eb9b651ca5e9" providerId="ADAL" clId="{2987604F-A8AA-42F5-AABA-D7B103F0407B}" dt="2024-12-17T15:18:47.120" v="688" actId="478"/>
          <ac:grpSpMkLst>
            <pc:docMk/>
            <pc:sldMk cId="3789454844" sldId="256"/>
            <ac:grpSpMk id="48" creationId="{D8A72DB8-5F1A-B7FC-BB44-13F750A545BB}"/>
          </ac:grpSpMkLst>
        </pc:grpChg>
        <pc:grpChg chg="mod">
          <ac:chgData name="LAURA MIOZZI" userId="c8ec988e-57c5-4106-9762-eb9b651ca5e9" providerId="ADAL" clId="{2987604F-A8AA-42F5-AABA-D7B103F0407B}" dt="2024-12-17T15:18:44.199" v="686"/>
          <ac:grpSpMkLst>
            <pc:docMk/>
            <pc:sldMk cId="3789454844" sldId="256"/>
            <ac:grpSpMk id="49" creationId="{123D99F0-AF54-AA04-E858-158832FDBEBC}"/>
          </ac:grpSpMkLst>
        </pc:grpChg>
        <pc:grpChg chg="add mod">
          <ac:chgData name="LAURA MIOZZI" userId="c8ec988e-57c5-4106-9762-eb9b651ca5e9" providerId="ADAL" clId="{2987604F-A8AA-42F5-AABA-D7B103F0407B}" dt="2024-12-17T15:53:49.714" v="1247" actId="164"/>
          <ac:grpSpMkLst>
            <pc:docMk/>
            <pc:sldMk cId="3789454844" sldId="256"/>
            <ac:grpSpMk id="58" creationId="{2121D005-7BC7-B66E-4230-6A2EFE606E20}"/>
          </ac:grpSpMkLst>
        </pc:grpChg>
        <pc:grpChg chg="add mod">
          <ac:chgData name="LAURA MIOZZI" userId="c8ec988e-57c5-4106-9762-eb9b651ca5e9" providerId="ADAL" clId="{2987604F-A8AA-42F5-AABA-D7B103F0407B}" dt="2024-12-17T15:53:49.714" v="1247" actId="164"/>
          <ac:grpSpMkLst>
            <pc:docMk/>
            <pc:sldMk cId="3789454844" sldId="256"/>
            <ac:grpSpMk id="59" creationId="{49287315-5390-DF09-949A-A03DC4947104}"/>
          </ac:grpSpMkLst>
        </pc:grpChg>
        <pc:grpChg chg="add del mod ord">
          <ac:chgData name="LAURA MIOZZI" userId="c8ec988e-57c5-4106-9762-eb9b651ca5e9" providerId="ADAL" clId="{2987604F-A8AA-42F5-AABA-D7B103F0407B}" dt="2024-12-17T15:45:57.615" v="1105" actId="165"/>
          <ac:grpSpMkLst>
            <pc:docMk/>
            <pc:sldMk cId="3789454844" sldId="256"/>
            <ac:grpSpMk id="60" creationId="{4237C6FD-E207-52F0-CF9E-84E5BEF72E20}"/>
          </ac:grpSpMkLst>
        </pc:grpChg>
        <pc:grpChg chg="add del mod">
          <ac:chgData name="LAURA MIOZZI" userId="c8ec988e-57c5-4106-9762-eb9b651ca5e9" providerId="ADAL" clId="{2987604F-A8AA-42F5-AABA-D7B103F0407B}" dt="2024-12-17T15:46:42.325" v="1121" actId="478"/>
          <ac:grpSpMkLst>
            <pc:docMk/>
            <pc:sldMk cId="3789454844" sldId="256"/>
            <ac:grpSpMk id="66" creationId="{B3AC24E1-E4C7-B574-756A-52762B818E6C}"/>
          </ac:grpSpMkLst>
        </pc:grpChg>
        <pc:grpChg chg="add mod">
          <ac:chgData name="LAURA MIOZZI" userId="c8ec988e-57c5-4106-9762-eb9b651ca5e9" providerId="ADAL" clId="{2987604F-A8AA-42F5-AABA-D7B103F0407B}" dt="2024-12-17T15:53:49.714" v="1247" actId="164"/>
          <ac:grpSpMkLst>
            <pc:docMk/>
            <pc:sldMk cId="3789454844" sldId="256"/>
            <ac:grpSpMk id="69" creationId="{7BDA1731-57F1-4948-C378-C3B57414EF4F}"/>
          </ac:grpSpMkLst>
        </pc:grpChg>
        <pc:grpChg chg="add mod">
          <ac:chgData name="LAURA MIOZZI" userId="c8ec988e-57c5-4106-9762-eb9b651ca5e9" providerId="ADAL" clId="{2987604F-A8AA-42F5-AABA-D7B103F0407B}" dt="2024-12-17T15:53:49.714" v="1247" actId="164"/>
          <ac:grpSpMkLst>
            <pc:docMk/>
            <pc:sldMk cId="3789454844" sldId="256"/>
            <ac:grpSpMk id="71" creationId="{FB4A93D2-DEB2-C248-D05D-802B984FDB0D}"/>
          </ac:grpSpMkLst>
        </pc:grpChg>
        <pc:grpChg chg="add mod">
          <ac:chgData name="LAURA MIOZZI" userId="c8ec988e-57c5-4106-9762-eb9b651ca5e9" providerId="ADAL" clId="{2987604F-A8AA-42F5-AABA-D7B103F0407B}" dt="2024-12-17T15:54:02.918" v="1249" actId="1076"/>
          <ac:grpSpMkLst>
            <pc:docMk/>
            <pc:sldMk cId="3789454844" sldId="256"/>
            <ac:grpSpMk id="72" creationId="{6B52C896-422F-8B51-6CCB-8DBA20B476B9}"/>
          </ac:grpSpMkLst>
        </pc:grpChg>
        <pc:picChg chg="add mod topLvl modCrop">
          <ac:chgData name="LAURA MIOZZI" userId="c8ec988e-57c5-4106-9762-eb9b651ca5e9" providerId="ADAL" clId="{2987604F-A8AA-42F5-AABA-D7B103F0407B}" dt="2024-12-17T15:47:42.043" v="1139" actId="14100"/>
          <ac:picMkLst>
            <pc:docMk/>
            <pc:sldMk cId="3789454844" sldId="256"/>
            <ac:picMk id="4" creationId="{90509D62-CF7D-6AA0-6D23-D2AB6776F888}"/>
          </ac:picMkLst>
        </pc:picChg>
        <pc:picChg chg="add">
          <ac:chgData name="LAURA MIOZZI" userId="c8ec988e-57c5-4106-9762-eb9b651ca5e9" providerId="ADAL" clId="{2987604F-A8AA-42F5-AABA-D7B103F0407B}" dt="2024-12-17T14:19:38.890" v="155"/>
          <ac:picMkLst>
            <pc:docMk/>
            <pc:sldMk cId="3789454844" sldId="256"/>
            <ac:picMk id="7" creationId="{AF0BC912-48EB-1C44-0F8A-83581E3D34CB}"/>
          </ac:picMkLst>
        </pc:picChg>
        <pc:picChg chg="add mod modCrop">
          <ac:chgData name="LAURA MIOZZI" userId="c8ec988e-57c5-4106-9762-eb9b651ca5e9" providerId="ADAL" clId="{2987604F-A8AA-42F5-AABA-D7B103F0407B}" dt="2024-12-17T15:48:07.578" v="1142" actId="14100"/>
          <ac:picMkLst>
            <pc:docMk/>
            <pc:sldMk cId="3789454844" sldId="256"/>
            <ac:picMk id="13" creationId="{E5203376-8B94-CD6D-2677-C0A4239B579E}"/>
          </ac:picMkLst>
        </pc:picChg>
        <pc:picChg chg="add mod modCrop">
          <ac:chgData name="LAURA MIOZZI" userId="c8ec988e-57c5-4106-9762-eb9b651ca5e9" providerId="ADAL" clId="{2987604F-A8AA-42F5-AABA-D7B103F0407B}" dt="2024-12-17T15:50:41.713" v="1177" actId="732"/>
          <ac:picMkLst>
            <pc:docMk/>
            <pc:sldMk cId="3789454844" sldId="256"/>
            <ac:picMk id="16" creationId="{82AC12B8-B57E-D39C-E5C4-A8BCEEF1A2AC}"/>
          </ac:picMkLst>
        </pc:picChg>
        <pc:picChg chg="add mod modCrop">
          <ac:chgData name="LAURA MIOZZI" userId="c8ec988e-57c5-4106-9762-eb9b651ca5e9" providerId="ADAL" clId="{2987604F-A8AA-42F5-AABA-D7B103F0407B}" dt="2024-12-17T15:51:11.488" v="1182" actId="732"/>
          <ac:picMkLst>
            <pc:docMk/>
            <pc:sldMk cId="3789454844" sldId="256"/>
            <ac:picMk id="19" creationId="{E7C0F73C-B52D-0451-737E-8B7F248ADD3F}"/>
          </ac:picMkLst>
        </pc:picChg>
        <pc:picChg chg="add mod modCrop">
          <ac:chgData name="LAURA MIOZZI" userId="c8ec988e-57c5-4106-9762-eb9b651ca5e9" providerId="ADAL" clId="{2987604F-A8AA-42F5-AABA-D7B103F0407B}" dt="2024-12-17T15:52:06.623" v="1190" actId="732"/>
          <ac:picMkLst>
            <pc:docMk/>
            <pc:sldMk cId="3789454844" sldId="256"/>
            <ac:picMk id="20" creationId="{76006291-45A5-CBE6-751C-BDF2C0F92C2F}"/>
          </ac:picMkLst>
        </pc:picChg>
        <pc:picChg chg="add mod modCrop">
          <ac:chgData name="LAURA MIOZZI" userId="c8ec988e-57c5-4106-9762-eb9b651ca5e9" providerId="ADAL" clId="{2987604F-A8AA-42F5-AABA-D7B103F0407B}" dt="2024-12-17T15:50:05.032" v="1172" actId="732"/>
          <ac:picMkLst>
            <pc:docMk/>
            <pc:sldMk cId="3789454844" sldId="256"/>
            <ac:picMk id="27" creationId="{8536A14B-7C7D-23E7-A4A2-19BC5AD4C5C6}"/>
          </ac:picMkLst>
        </pc:picChg>
        <pc:picChg chg="add">
          <ac:chgData name="LAURA MIOZZI" userId="c8ec988e-57c5-4106-9762-eb9b651ca5e9" providerId="ADAL" clId="{2987604F-A8AA-42F5-AABA-D7B103F0407B}" dt="2024-12-17T15:03:40.431" v="530"/>
          <ac:picMkLst>
            <pc:docMk/>
            <pc:sldMk cId="3789454844" sldId="256"/>
            <ac:picMk id="31" creationId="{4853A188-1661-D605-B023-A17EB79AE9C5}"/>
          </ac:picMkLst>
        </pc:picChg>
        <pc:picChg chg="mod">
          <ac:chgData name="LAURA MIOZZI" userId="c8ec988e-57c5-4106-9762-eb9b651ca5e9" providerId="ADAL" clId="{2987604F-A8AA-42F5-AABA-D7B103F0407B}" dt="2024-12-17T15:03:43.080" v="531"/>
          <ac:picMkLst>
            <pc:docMk/>
            <pc:sldMk cId="3789454844" sldId="256"/>
            <ac:picMk id="33" creationId="{8536A14B-7C7D-23E7-A4A2-19BC5AD4C5C6}"/>
          </ac:picMkLst>
        </pc:picChg>
        <pc:picChg chg="add del mod topLvl modCrop">
          <ac:chgData name="LAURA MIOZZI" userId="c8ec988e-57c5-4106-9762-eb9b651ca5e9" providerId="ADAL" clId="{2987604F-A8AA-42F5-AABA-D7B103F0407B}" dt="2024-12-17T15:45:08.062" v="1098" actId="478"/>
          <ac:picMkLst>
            <pc:docMk/>
            <pc:sldMk cId="3789454844" sldId="256"/>
            <ac:picMk id="38" creationId="{515643BC-3AAE-3CBE-5B74-0F5BAF037740}"/>
          </ac:picMkLst>
        </pc:picChg>
        <pc:picChg chg="mod">
          <ac:chgData name="LAURA MIOZZI" userId="c8ec988e-57c5-4106-9762-eb9b651ca5e9" providerId="ADAL" clId="{2987604F-A8AA-42F5-AABA-D7B103F0407B}" dt="2024-12-17T15:18:04" v="682"/>
          <ac:picMkLst>
            <pc:docMk/>
            <pc:sldMk cId="3789454844" sldId="256"/>
            <ac:picMk id="43" creationId="{F744CACB-0F38-CCAF-9096-9890881AAE72}"/>
          </ac:picMkLst>
        </pc:picChg>
        <pc:picChg chg="mod">
          <ac:chgData name="LAURA MIOZZI" userId="c8ec988e-57c5-4106-9762-eb9b651ca5e9" providerId="ADAL" clId="{2987604F-A8AA-42F5-AABA-D7B103F0407B}" dt="2024-12-17T15:18:04" v="682"/>
          <ac:picMkLst>
            <pc:docMk/>
            <pc:sldMk cId="3789454844" sldId="256"/>
            <ac:picMk id="44" creationId="{3BBD0DA9-49ED-49E0-CFBB-C37DA1EC97D4}"/>
          </ac:picMkLst>
        </pc:picChg>
        <pc:picChg chg="mod">
          <ac:chgData name="LAURA MIOZZI" userId="c8ec988e-57c5-4106-9762-eb9b651ca5e9" providerId="ADAL" clId="{2987604F-A8AA-42F5-AABA-D7B103F0407B}" dt="2024-12-17T15:18:04" v="682"/>
          <ac:picMkLst>
            <pc:docMk/>
            <pc:sldMk cId="3789454844" sldId="256"/>
            <ac:picMk id="45" creationId="{D7707216-4FEA-9BB3-3D2F-24DAF0C6063E}"/>
          </ac:picMkLst>
        </pc:picChg>
        <pc:picChg chg="mod">
          <ac:chgData name="LAURA MIOZZI" userId="c8ec988e-57c5-4106-9762-eb9b651ca5e9" providerId="ADAL" clId="{2987604F-A8AA-42F5-AABA-D7B103F0407B}" dt="2024-12-17T15:18:04" v="682"/>
          <ac:picMkLst>
            <pc:docMk/>
            <pc:sldMk cId="3789454844" sldId="256"/>
            <ac:picMk id="46" creationId="{E1EEF7C4-C201-89DE-B85B-1186A6A80A2C}"/>
          </ac:picMkLst>
        </pc:picChg>
        <pc:picChg chg="mod">
          <ac:chgData name="LAURA MIOZZI" userId="c8ec988e-57c5-4106-9762-eb9b651ca5e9" providerId="ADAL" clId="{2987604F-A8AA-42F5-AABA-D7B103F0407B}" dt="2024-12-17T15:18:04" v="682"/>
          <ac:picMkLst>
            <pc:docMk/>
            <pc:sldMk cId="3789454844" sldId="256"/>
            <ac:picMk id="47" creationId="{66FC5405-777C-B50E-9F5A-F74DC370DF0D}"/>
          </ac:picMkLst>
        </pc:picChg>
        <pc:picChg chg="mod">
          <ac:chgData name="LAURA MIOZZI" userId="c8ec988e-57c5-4106-9762-eb9b651ca5e9" providerId="ADAL" clId="{2987604F-A8AA-42F5-AABA-D7B103F0407B}" dt="2024-12-17T15:18:44.199" v="686"/>
          <ac:picMkLst>
            <pc:docMk/>
            <pc:sldMk cId="3789454844" sldId="256"/>
            <ac:picMk id="51" creationId="{64B742F0-CC32-E9A2-5A50-EF06FB2B9210}"/>
          </ac:picMkLst>
        </pc:picChg>
        <pc:picChg chg="add del mod modCrop">
          <ac:chgData name="LAURA MIOZZI" userId="c8ec988e-57c5-4106-9762-eb9b651ca5e9" providerId="ADAL" clId="{2987604F-A8AA-42F5-AABA-D7B103F0407B}" dt="2024-12-17T15:37:51.865" v="816" actId="478"/>
          <ac:picMkLst>
            <pc:docMk/>
            <pc:sldMk cId="3789454844" sldId="256"/>
            <ac:picMk id="55" creationId="{05B441D3-F40E-1ACC-7F90-6B6A0F7D9EB0}"/>
          </ac:picMkLst>
        </pc:picChg>
        <pc:picChg chg="add mod modCrop">
          <ac:chgData name="LAURA MIOZZI" userId="c8ec988e-57c5-4106-9762-eb9b651ca5e9" providerId="ADAL" clId="{2987604F-A8AA-42F5-AABA-D7B103F0407B}" dt="2024-12-17T15:39:13.135" v="831" actId="164"/>
          <ac:picMkLst>
            <pc:docMk/>
            <pc:sldMk cId="3789454844" sldId="256"/>
            <ac:picMk id="56" creationId="{ECD03B49-C622-5094-9693-ECC1D82EB1F8}"/>
          </ac:picMkLst>
        </pc:picChg>
        <pc:picChg chg="mod topLvl">
          <ac:chgData name="LAURA MIOZZI" userId="c8ec988e-57c5-4106-9762-eb9b651ca5e9" providerId="ADAL" clId="{2987604F-A8AA-42F5-AABA-D7B103F0407B}" dt="2024-12-17T15:46:02.048" v="1106" actId="164"/>
          <ac:picMkLst>
            <pc:docMk/>
            <pc:sldMk cId="3789454844" sldId="256"/>
            <ac:picMk id="61" creationId="{3300755F-E70F-A01A-4C50-7925B06B9D33}"/>
          </ac:picMkLst>
        </pc:picChg>
        <pc:picChg chg="mod topLvl">
          <ac:chgData name="LAURA MIOZZI" userId="c8ec988e-57c5-4106-9762-eb9b651ca5e9" providerId="ADAL" clId="{2987604F-A8AA-42F5-AABA-D7B103F0407B}" dt="2024-12-17T15:46:02.048" v="1106" actId="164"/>
          <ac:picMkLst>
            <pc:docMk/>
            <pc:sldMk cId="3789454844" sldId="256"/>
            <ac:picMk id="62" creationId="{0EE180D0-D902-B978-8537-32E0E8441C18}"/>
          </ac:picMkLst>
        </pc:picChg>
        <pc:picChg chg="mod topLvl">
          <ac:chgData name="LAURA MIOZZI" userId="c8ec988e-57c5-4106-9762-eb9b651ca5e9" providerId="ADAL" clId="{2987604F-A8AA-42F5-AABA-D7B103F0407B}" dt="2024-12-17T15:46:02.048" v="1106" actId="164"/>
          <ac:picMkLst>
            <pc:docMk/>
            <pc:sldMk cId="3789454844" sldId="256"/>
            <ac:picMk id="63" creationId="{3E20112C-3994-D64D-6E70-5A806DAB33DC}"/>
          </ac:picMkLst>
        </pc:picChg>
        <pc:picChg chg="add">
          <ac:chgData name="LAURA MIOZZI" userId="c8ec988e-57c5-4106-9762-eb9b651ca5e9" providerId="ADAL" clId="{2987604F-A8AA-42F5-AABA-D7B103F0407B}" dt="2024-12-17T15:45:26.549" v="1101"/>
          <ac:picMkLst>
            <pc:docMk/>
            <pc:sldMk cId="3789454844" sldId="256"/>
            <ac:picMk id="64" creationId="{F27B2CF9-0FA3-B2AB-AECF-267DE3E6AF11}"/>
          </ac:picMkLst>
        </pc:picChg>
        <pc:picChg chg="add">
          <ac:chgData name="LAURA MIOZZI" userId="c8ec988e-57c5-4106-9762-eb9b651ca5e9" providerId="ADAL" clId="{2987604F-A8AA-42F5-AABA-D7B103F0407B}" dt="2024-12-17T15:45:35.676" v="1102"/>
          <ac:picMkLst>
            <pc:docMk/>
            <pc:sldMk cId="3789454844" sldId="256"/>
            <ac:picMk id="65" creationId="{93B602CD-2A59-E1BA-45C5-18C89928F643}"/>
          </ac:picMkLst>
        </pc:picChg>
        <pc:picChg chg="add mod">
          <ac:chgData name="LAURA MIOZZI" userId="c8ec988e-57c5-4106-9762-eb9b651ca5e9" providerId="ADAL" clId="{2987604F-A8AA-42F5-AABA-D7B103F0407B}" dt="2024-12-17T15:46:07.695" v="1109" actId="1076"/>
          <ac:picMkLst>
            <pc:docMk/>
            <pc:sldMk cId="3789454844" sldId="256"/>
            <ac:picMk id="67" creationId="{08A9ECCC-6B2A-42C0-A8B5-1D9BFF1B2A10}"/>
          </ac:picMkLst>
        </pc:picChg>
        <pc:picChg chg="add mod ord">
          <ac:chgData name="LAURA MIOZZI" userId="c8ec988e-57c5-4106-9762-eb9b651ca5e9" providerId="ADAL" clId="{2987604F-A8AA-42F5-AABA-D7B103F0407B}" dt="2024-12-17T15:47:23.318" v="1136" actId="164"/>
          <ac:picMkLst>
            <pc:docMk/>
            <pc:sldMk cId="3789454844" sldId="256"/>
            <ac:picMk id="68" creationId="{B6AC2AB8-5AAA-2871-9152-5A6FD3148F05}"/>
          </ac:picMkLst>
        </pc:picChg>
      </pc:sldChg>
    </pc:docChg>
  </pc:docChgLst>
  <pc:docChgLst>
    <pc:chgData name="LAURA MIOZZI" userId="S::laura.miozzi@cnr.it::c8ec988e-57c5-4106-9762-eb9b651ca5e9" providerId="AD" clId="Web-{EDFA93D4-4392-5BAF-169F-75D2E1E7671C}"/>
    <pc:docChg chg="modSld">
      <pc:chgData name="LAURA MIOZZI" userId="S::laura.miozzi@cnr.it::c8ec988e-57c5-4106-9762-eb9b651ca5e9" providerId="AD" clId="Web-{EDFA93D4-4392-5BAF-169F-75D2E1E7671C}" dt="2025-01-22T09:06:52.017" v="95" actId="20577"/>
      <pc:docMkLst>
        <pc:docMk/>
      </pc:docMkLst>
      <pc:sldChg chg="modSp">
        <pc:chgData name="LAURA MIOZZI" userId="S::laura.miozzi@cnr.it::c8ec988e-57c5-4106-9762-eb9b651ca5e9" providerId="AD" clId="Web-{EDFA93D4-4392-5BAF-169F-75D2E1E7671C}" dt="2025-01-22T09:06:52.017" v="95" actId="20577"/>
        <pc:sldMkLst>
          <pc:docMk/>
          <pc:sldMk cId="3789454844" sldId="256"/>
        </pc:sldMkLst>
        <pc:spChg chg="mod">
          <ac:chgData name="LAURA MIOZZI" userId="S::laura.miozzi@cnr.it::c8ec988e-57c5-4106-9762-eb9b651ca5e9" providerId="AD" clId="Web-{EDFA93D4-4392-5BAF-169F-75D2E1E7671C}" dt="2025-01-22T09:06:52.017" v="95" actId="20577"/>
          <ac:spMkLst>
            <pc:docMk/>
            <pc:sldMk cId="3789454844" sldId="256"/>
            <ac:spMk id="5" creationId="{D0862031-F6F8-CD8A-1223-FCD978ADAEE8}"/>
          </ac:spMkLst>
        </pc:spChg>
        <pc:spChg chg="mod">
          <ac:chgData name="LAURA MIOZZI" userId="S::laura.miozzi@cnr.it::c8ec988e-57c5-4106-9762-eb9b651ca5e9" providerId="AD" clId="Web-{EDFA93D4-4392-5BAF-169F-75D2E1E7671C}" dt="2025-01-22T09:04:30.794" v="20" actId="1076"/>
          <ac:spMkLst>
            <pc:docMk/>
            <pc:sldMk cId="3789454844" sldId="256"/>
            <ac:spMk id="24" creationId="{C7C5D0FA-9335-DBF2-E6BA-33C3F07EF4E0}"/>
          </ac:spMkLst>
        </pc:spChg>
      </pc:sldChg>
    </pc:docChg>
  </pc:docChgLst>
  <pc:docChgLst>
    <pc:chgData name="ANNA MARIA VAIRA" userId="07571697-e96e-4085-b98c-c13b660e5005" providerId="ADAL" clId="{C630031A-33E5-4A8B-9E15-850B94F616CB}"/>
    <pc:docChg chg="undo custSel addSld delSld modSld">
      <pc:chgData name="ANNA MARIA VAIRA" userId="07571697-e96e-4085-b98c-c13b660e5005" providerId="ADAL" clId="{C630031A-33E5-4A8B-9E15-850B94F616CB}" dt="2025-02-19T18:46:41.035" v="1073" actId="20577"/>
      <pc:docMkLst>
        <pc:docMk/>
      </pc:docMkLst>
      <pc:sldChg chg="addSp delSp modSp">
        <pc:chgData name="ANNA MARIA VAIRA" userId="07571697-e96e-4085-b98c-c13b660e5005" providerId="ADAL" clId="{C630031A-33E5-4A8B-9E15-850B94F616CB}" dt="2025-02-19T18:46:41.035" v="1073" actId="20577"/>
        <pc:sldMkLst>
          <pc:docMk/>
          <pc:sldMk cId="3789454844" sldId="256"/>
        </pc:sldMkLst>
        <pc:spChg chg="add del mod">
          <ac:chgData name="ANNA MARIA VAIRA" userId="07571697-e96e-4085-b98c-c13b660e5005" providerId="ADAL" clId="{C630031A-33E5-4A8B-9E15-850B94F616CB}" dt="2025-02-19T18:05:39.228" v="39" actId="478"/>
          <ac:spMkLst>
            <pc:docMk/>
            <pc:sldMk cId="3789454844" sldId="256"/>
            <ac:spMk id="2" creationId="{810C0299-F2A5-4955-ADF6-92E175CA16C5}"/>
          </ac:spMkLst>
        </pc:spChg>
        <pc:spChg chg="add mod topLvl">
          <ac:chgData name="ANNA MARIA VAIRA" userId="07571697-e96e-4085-b98c-c13b660e5005" providerId="ADAL" clId="{C630031A-33E5-4A8B-9E15-850B94F616CB}" dt="2025-02-19T18:45:34.702" v="1063" actId="164"/>
          <ac:spMkLst>
            <pc:docMk/>
            <pc:sldMk cId="3789454844" sldId="256"/>
            <ac:spMk id="3" creationId="{8BF14B3F-49A8-4CBC-9847-E27A53D7515D}"/>
          </ac:spMkLst>
        </pc:spChg>
        <pc:spChg chg="add mod topLvl">
          <ac:chgData name="ANNA MARIA VAIRA" userId="07571697-e96e-4085-b98c-c13b660e5005" providerId="ADAL" clId="{C630031A-33E5-4A8B-9E15-850B94F616CB}" dt="2025-02-19T18:45:34.702" v="1063" actId="164"/>
          <ac:spMkLst>
            <pc:docMk/>
            <pc:sldMk cId="3789454844" sldId="256"/>
            <ac:spMk id="7" creationId="{824E08DE-28DA-43E3-BBCA-E04AE73F9FC0}"/>
          </ac:spMkLst>
        </pc:spChg>
        <pc:spChg chg="mod">
          <ac:chgData name="ANNA MARIA VAIRA" userId="07571697-e96e-4085-b98c-c13b660e5005" providerId="ADAL" clId="{C630031A-33E5-4A8B-9E15-850B94F616CB}" dt="2025-02-19T18:46:14.049" v="1069" actId="20577"/>
          <ac:spMkLst>
            <pc:docMk/>
            <pc:sldMk cId="3789454844" sldId="256"/>
            <ac:spMk id="8" creationId="{7A9EAF35-B2A2-6828-CD2A-3552D833A1FA}"/>
          </ac:spMkLst>
        </pc:spChg>
        <pc:spChg chg="mod">
          <ac:chgData name="ANNA MARIA VAIRA" userId="07571697-e96e-4085-b98c-c13b660e5005" providerId="ADAL" clId="{C630031A-33E5-4A8B-9E15-850B94F616CB}" dt="2025-02-05T11:43:13.700" v="38" actId="20577"/>
          <ac:spMkLst>
            <pc:docMk/>
            <pc:sldMk cId="3789454844" sldId="256"/>
            <ac:spMk id="14" creationId="{93371108-6244-38F4-80DD-0CD5D2685E83}"/>
          </ac:spMkLst>
        </pc:spChg>
        <pc:spChg chg="add mod">
          <ac:chgData name="ANNA MARIA VAIRA" userId="07571697-e96e-4085-b98c-c13b660e5005" providerId="ADAL" clId="{C630031A-33E5-4A8B-9E15-850B94F616CB}" dt="2025-02-19T18:36:01.708" v="999"/>
          <ac:spMkLst>
            <pc:docMk/>
            <pc:sldMk cId="3789454844" sldId="256"/>
            <ac:spMk id="49" creationId="{815AE0C7-2135-4EBA-95B9-412F18B0D88F}"/>
          </ac:spMkLst>
        </pc:spChg>
        <pc:spChg chg="mod">
          <ac:chgData name="ANNA MARIA VAIRA" userId="07571697-e96e-4085-b98c-c13b660e5005" providerId="ADAL" clId="{C630031A-33E5-4A8B-9E15-850B94F616CB}" dt="2025-02-19T18:46:41.035" v="1073" actId="20577"/>
          <ac:spMkLst>
            <pc:docMk/>
            <pc:sldMk cId="3789454844" sldId="256"/>
            <ac:spMk id="70" creationId="{F25B2E67-6A62-8B35-4906-8D758DC91A41}"/>
          </ac:spMkLst>
        </pc:spChg>
        <pc:grpChg chg="add del mod">
          <ac:chgData name="ANNA MARIA VAIRA" userId="07571697-e96e-4085-b98c-c13b660e5005" providerId="ADAL" clId="{C630031A-33E5-4A8B-9E15-850B94F616CB}" dt="2025-02-19T18:44:50.946" v="1060" actId="165"/>
          <ac:grpSpMkLst>
            <pc:docMk/>
            <pc:sldMk cId="3789454844" sldId="256"/>
            <ac:grpSpMk id="9" creationId="{8F16CE05-5575-457D-ADF2-F4A04DB8A0AA}"/>
          </ac:grpSpMkLst>
        </pc:grpChg>
        <pc:grpChg chg="add mod">
          <ac:chgData name="ANNA MARIA VAIRA" userId="07571697-e96e-4085-b98c-c13b660e5005" providerId="ADAL" clId="{C630031A-33E5-4A8B-9E15-850B94F616CB}" dt="2025-02-19T18:45:34.702" v="1063" actId="164"/>
          <ac:grpSpMkLst>
            <pc:docMk/>
            <pc:sldMk cId="3789454844" sldId="256"/>
            <ac:grpSpMk id="10" creationId="{244D0B83-1B6F-4A56-815B-F8EE52E365EA}"/>
          </ac:grpSpMkLst>
        </pc:grpChg>
        <pc:grpChg chg="mod topLvl">
          <ac:chgData name="ANNA MARIA VAIRA" userId="07571697-e96e-4085-b98c-c13b660e5005" providerId="ADAL" clId="{C630031A-33E5-4A8B-9E15-850B94F616CB}" dt="2025-02-19T18:35:25.014" v="942" actId="165"/>
          <ac:grpSpMkLst>
            <pc:docMk/>
            <pc:sldMk cId="3789454844" sldId="256"/>
            <ac:grpSpMk id="36" creationId="{32A559C6-3781-4D7C-88C6-2FEDBAFB4544}"/>
          </ac:grpSpMkLst>
        </pc:grpChg>
        <pc:grpChg chg="mod topLvl">
          <ac:chgData name="ANNA MARIA VAIRA" userId="07571697-e96e-4085-b98c-c13b660e5005" providerId="ADAL" clId="{C630031A-33E5-4A8B-9E15-850B94F616CB}" dt="2025-02-19T18:35:25.014" v="942" actId="165"/>
          <ac:grpSpMkLst>
            <pc:docMk/>
            <pc:sldMk cId="3789454844" sldId="256"/>
            <ac:grpSpMk id="37" creationId="{59487048-F850-32BC-977A-6490B4BC9CAD}"/>
          </ac:grpSpMkLst>
        </pc:grpChg>
        <pc:grpChg chg="add del mod">
          <ac:chgData name="ANNA MARIA VAIRA" userId="07571697-e96e-4085-b98c-c13b660e5005" providerId="ADAL" clId="{C630031A-33E5-4A8B-9E15-850B94F616CB}" dt="2025-02-19T18:40:09.901" v="1032" actId="165"/>
          <ac:grpSpMkLst>
            <pc:docMk/>
            <pc:sldMk cId="3789454844" sldId="256"/>
            <ac:grpSpMk id="41" creationId="{EF48D018-9104-47FA-A12B-FBDF8E97DF95}"/>
          </ac:grpSpMkLst>
        </pc:grpChg>
        <pc:grpChg chg="del mod topLvl">
          <ac:chgData name="ANNA MARIA VAIRA" userId="07571697-e96e-4085-b98c-c13b660e5005" providerId="ADAL" clId="{C630031A-33E5-4A8B-9E15-850B94F616CB}" dt="2025-02-19T18:43:24.057" v="1055" actId="478"/>
          <ac:grpSpMkLst>
            <pc:docMk/>
            <pc:sldMk cId="3789454844" sldId="256"/>
            <ac:grpSpMk id="58" creationId="{2121D005-7BC7-B66E-4230-6A2EFE606E20}"/>
          </ac:grpSpMkLst>
        </pc:grpChg>
        <pc:grpChg chg="mod topLvl">
          <ac:chgData name="ANNA MARIA VAIRA" userId="07571697-e96e-4085-b98c-c13b660e5005" providerId="ADAL" clId="{C630031A-33E5-4A8B-9E15-850B94F616CB}" dt="2025-02-19T18:35:25.014" v="942" actId="165"/>
          <ac:grpSpMkLst>
            <pc:docMk/>
            <pc:sldMk cId="3789454844" sldId="256"/>
            <ac:grpSpMk id="59" creationId="{49287315-5390-DF09-949A-A03DC4947104}"/>
          </ac:grpSpMkLst>
        </pc:grpChg>
        <pc:grpChg chg="mod topLvl">
          <ac:chgData name="ANNA MARIA VAIRA" userId="07571697-e96e-4085-b98c-c13b660e5005" providerId="ADAL" clId="{C630031A-33E5-4A8B-9E15-850B94F616CB}" dt="2025-02-19T18:35:25.014" v="942" actId="165"/>
          <ac:grpSpMkLst>
            <pc:docMk/>
            <pc:sldMk cId="3789454844" sldId="256"/>
            <ac:grpSpMk id="69" creationId="{7BDA1731-57F1-4948-C378-C3B57414EF4F}"/>
          </ac:grpSpMkLst>
        </pc:grpChg>
        <pc:grpChg chg="mod topLvl">
          <ac:chgData name="ANNA MARIA VAIRA" userId="07571697-e96e-4085-b98c-c13b660e5005" providerId="ADAL" clId="{C630031A-33E5-4A8B-9E15-850B94F616CB}" dt="2025-02-19T18:35:25.014" v="942" actId="165"/>
          <ac:grpSpMkLst>
            <pc:docMk/>
            <pc:sldMk cId="3789454844" sldId="256"/>
            <ac:grpSpMk id="71" creationId="{FB4A93D2-DEB2-C248-D05D-802B984FDB0D}"/>
          </ac:grpSpMkLst>
        </pc:grpChg>
        <pc:grpChg chg="del">
          <ac:chgData name="ANNA MARIA VAIRA" userId="07571697-e96e-4085-b98c-c13b660e5005" providerId="ADAL" clId="{C630031A-33E5-4A8B-9E15-850B94F616CB}" dt="2025-02-19T18:35:25.014" v="942" actId="165"/>
          <ac:grpSpMkLst>
            <pc:docMk/>
            <pc:sldMk cId="3789454844" sldId="256"/>
            <ac:grpSpMk id="72" creationId="{6B52C896-422F-8B51-6CCB-8DBA20B476B9}"/>
          </ac:grpSpMkLst>
        </pc:grpChg>
        <pc:picChg chg="mod topLvl modCrop">
          <ac:chgData name="ANNA MARIA VAIRA" userId="07571697-e96e-4085-b98c-c13b660e5005" providerId="ADAL" clId="{C630031A-33E5-4A8B-9E15-850B94F616CB}" dt="2025-02-19T18:45:34.702" v="1063" actId="164"/>
          <ac:picMkLst>
            <pc:docMk/>
            <pc:sldMk cId="3789454844" sldId="256"/>
            <ac:picMk id="42" creationId="{95DBC3A1-1E1B-4B61-B2B5-9AFA11FC0E0F}"/>
          </ac:picMkLst>
        </pc:picChg>
        <pc:picChg chg="mod topLvl">
          <ac:chgData name="ANNA MARIA VAIRA" userId="07571697-e96e-4085-b98c-c13b660e5005" providerId="ADAL" clId="{C630031A-33E5-4A8B-9E15-850B94F616CB}" dt="2025-02-19T18:45:34.702" v="1063" actId="164"/>
          <ac:picMkLst>
            <pc:docMk/>
            <pc:sldMk cId="3789454844" sldId="256"/>
            <ac:picMk id="43" creationId="{918ABB40-701E-4E63-9B90-B1C5D682A8EC}"/>
          </ac:picMkLst>
        </pc:picChg>
        <pc:picChg chg="mod ord topLvl modCrop">
          <ac:chgData name="ANNA MARIA VAIRA" userId="07571697-e96e-4085-b98c-c13b660e5005" providerId="ADAL" clId="{C630031A-33E5-4A8B-9E15-850B94F616CB}" dt="2025-02-19T18:45:34.702" v="1063" actId="164"/>
          <ac:picMkLst>
            <pc:docMk/>
            <pc:sldMk cId="3789454844" sldId="256"/>
            <ac:picMk id="44" creationId="{F9192054-B5D4-4679-AD5F-7E719F79D0F3}"/>
          </ac:picMkLst>
        </pc:picChg>
        <pc:picChg chg="mod ord topLvl modCrop">
          <ac:chgData name="ANNA MARIA VAIRA" userId="07571697-e96e-4085-b98c-c13b660e5005" providerId="ADAL" clId="{C630031A-33E5-4A8B-9E15-850B94F616CB}" dt="2025-02-19T18:45:34.702" v="1063" actId="164"/>
          <ac:picMkLst>
            <pc:docMk/>
            <pc:sldMk cId="3789454844" sldId="256"/>
            <ac:picMk id="45" creationId="{C8F62B0F-0F0D-410A-A03C-F8BD5681B9B7}"/>
          </ac:picMkLst>
        </pc:picChg>
        <pc:picChg chg="mod ord topLvl">
          <ac:chgData name="ANNA MARIA VAIRA" userId="07571697-e96e-4085-b98c-c13b660e5005" providerId="ADAL" clId="{C630031A-33E5-4A8B-9E15-850B94F616CB}" dt="2025-02-19T18:45:34.702" v="1063" actId="164"/>
          <ac:picMkLst>
            <pc:docMk/>
            <pc:sldMk cId="3789454844" sldId="256"/>
            <ac:picMk id="46" creationId="{786DAA47-4B9E-403F-9046-94B4C045C531}"/>
          </ac:picMkLst>
        </pc:picChg>
        <pc:picChg chg="mod topLvl">
          <ac:chgData name="ANNA MARIA VAIRA" userId="07571697-e96e-4085-b98c-c13b660e5005" providerId="ADAL" clId="{C630031A-33E5-4A8B-9E15-850B94F616CB}" dt="2025-02-19T18:45:34.702" v="1063" actId="164"/>
          <ac:picMkLst>
            <pc:docMk/>
            <pc:sldMk cId="3789454844" sldId="256"/>
            <ac:picMk id="47" creationId="{91641B11-47CA-4B9E-81FE-73CF7F5A421A}"/>
          </ac:picMkLst>
        </pc:picChg>
        <pc:picChg chg="mod topLvl modCrop">
          <ac:chgData name="ANNA MARIA VAIRA" userId="07571697-e96e-4085-b98c-c13b660e5005" providerId="ADAL" clId="{C630031A-33E5-4A8B-9E15-850B94F616CB}" dt="2025-02-19T18:45:34.702" v="1063" actId="164"/>
          <ac:picMkLst>
            <pc:docMk/>
            <pc:sldMk cId="3789454844" sldId="256"/>
            <ac:picMk id="48" creationId="{F18D4883-9867-48FA-AA1B-BE58A5D69EE8}"/>
          </ac:picMkLst>
        </pc:picChg>
      </pc:sldChg>
      <pc:sldChg chg="addSp delSp modSp add del">
        <pc:chgData name="ANNA MARIA VAIRA" userId="07571697-e96e-4085-b98c-c13b660e5005" providerId="ADAL" clId="{C630031A-33E5-4A8B-9E15-850B94F616CB}" dt="2025-02-19T18:43:34.116" v="1056" actId="2696"/>
        <pc:sldMkLst>
          <pc:docMk/>
          <pc:sldMk cId="4227259215" sldId="257"/>
        </pc:sldMkLst>
        <pc:spChg chg="del">
          <ac:chgData name="ANNA MARIA VAIRA" userId="07571697-e96e-4085-b98c-c13b660e5005" providerId="ADAL" clId="{C630031A-33E5-4A8B-9E15-850B94F616CB}" dt="2025-02-19T18:06:01.813" v="42" actId="478"/>
          <ac:spMkLst>
            <pc:docMk/>
            <pc:sldMk cId="4227259215" sldId="257"/>
            <ac:spMk id="2" creationId="{118F8B22-E74A-45D4-9012-3787CF083953}"/>
          </ac:spMkLst>
        </pc:spChg>
        <pc:spChg chg="del">
          <ac:chgData name="ANNA MARIA VAIRA" userId="07571697-e96e-4085-b98c-c13b660e5005" providerId="ADAL" clId="{C630031A-33E5-4A8B-9E15-850B94F616CB}" dt="2025-02-19T18:05:58.580" v="41" actId="478"/>
          <ac:spMkLst>
            <pc:docMk/>
            <pc:sldMk cId="4227259215" sldId="257"/>
            <ac:spMk id="3" creationId="{024D78F1-6D6E-429C-896C-7C2BB6E0B836}"/>
          </ac:spMkLst>
        </pc:spChg>
        <pc:grpChg chg="add del mod">
          <ac:chgData name="ANNA MARIA VAIRA" userId="07571697-e96e-4085-b98c-c13b660e5005" providerId="ADAL" clId="{C630031A-33E5-4A8B-9E15-850B94F616CB}" dt="2025-02-19T18:25:55.628" v="840" actId="165"/>
          <ac:grpSpMkLst>
            <pc:docMk/>
            <pc:sldMk cId="4227259215" sldId="257"/>
            <ac:grpSpMk id="17" creationId="{1915D4DE-45DB-4FB1-8418-287D60933289}"/>
          </ac:grpSpMkLst>
        </pc:grpChg>
        <pc:grpChg chg="add del mod">
          <ac:chgData name="ANNA MARIA VAIRA" userId="07571697-e96e-4085-b98c-c13b660e5005" providerId="ADAL" clId="{C630031A-33E5-4A8B-9E15-850B94F616CB}" dt="2025-02-19T18:29:50.441" v="858" actId="165"/>
          <ac:grpSpMkLst>
            <pc:docMk/>
            <pc:sldMk cId="4227259215" sldId="257"/>
            <ac:grpSpMk id="18" creationId="{9B616FD0-CBED-4FAE-ACFE-AAF2F2312436}"/>
          </ac:grpSpMkLst>
        </pc:grpChg>
        <pc:grpChg chg="add mod">
          <ac:chgData name="ANNA MARIA VAIRA" userId="07571697-e96e-4085-b98c-c13b660e5005" providerId="ADAL" clId="{C630031A-33E5-4A8B-9E15-850B94F616CB}" dt="2025-02-19T18:33:34.344" v="922" actId="164"/>
          <ac:grpSpMkLst>
            <pc:docMk/>
            <pc:sldMk cId="4227259215" sldId="257"/>
            <ac:grpSpMk id="19" creationId="{570A8F8C-901C-4F79-A926-45E548D2F2BC}"/>
          </ac:grpSpMkLst>
        </pc:grpChg>
        <pc:picChg chg="add del mod modCrop">
          <ac:chgData name="ANNA MARIA VAIRA" userId="07571697-e96e-4085-b98c-c13b660e5005" providerId="ADAL" clId="{C630031A-33E5-4A8B-9E15-850B94F616CB}" dt="2025-02-19T18:18:28.037" v="503" actId="478"/>
          <ac:picMkLst>
            <pc:docMk/>
            <pc:sldMk cId="4227259215" sldId="257"/>
            <ac:picMk id="5" creationId="{3CEA951C-C6D0-4F40-B0EC-3612C9528F8B}"/>
          </ac:picMkLst>
        </pc:picChg>
        <pc:picChg chg="add del mod">
          <ac:chgData name="ANNA MARIA VAIRA" userId="07571697-e96e-4085-b98c-c13b660e5005" providerId="ADAL" clId="{C630031A-33E5-4A8B-9E15-850B94F616CB}" dt="2025-02-19T18:12:12.354" v="49" actId="478"/>
          <ac:picMkLst>
            <pc:docMk/>
            <pc:sldMk cId="4227259215" sldId="257"/>
            <ac:picMk id="7" creationId="{2351AC49-61AD-4EDF-A4B2-1B0F1C45C43C}"/>
          </ac:picMkLst>
        </pc:picChg>
        <pc:picChg chg="add del mod modCrop">
          <ac:chgData name="ANNA MARIA VAIRA" userId="07571697-e96e-4085-b98c-c13b660e5005" providerId="ADAL" clId="{C630031A-33E5-4A8B-9E15-850B94F616CB}" dt="2025-02-19T18:16:26.324" v="426" actId="478"/>
          <ac:picMkLst>
            <pc:docMk/>
            <pc:sldMk cId="4227259215" sldId="257"/>
            <ac:picMk id="8" creationId="{70040793-4015-4C5C-8375-2E498969C4A3}"/>
          </ac:picMkLst>
        </pc:picChg>
        <pc:picChg chg="add mod topLvl modCrop">
          <ac:chgData name="ANNA MARIA VAIRA" userId="07571697-e96e-4085-b98c-c13b660e5005" providerId="ADAL" clId="{C630031A-33E5-4A8B-9E15-850B94F616CB}" dt="2025-02-19T18:33:34.344" v="922" actId="164"/>
          <ac:picMkLst>
            <pc:docMk/>
            <pc:sldMk cId="4227259215" sldId="257"/>
            <ac:picMk id="9" creationId="{FA0A26FD-890B-443B-B1E6-8394B3A1D921}"/>
          </ac:picMkLst>
        </pc:picChg>
        <pc:picChg chg="add mod topLvl modCrop">
          <ac:chgData name="ANNA MARIA VAIRA" userId="07571697-e96e-4085-b98c-c13b660e5005" providerId="ADAL" clId="{C630031A-33E5-4A8B-9E15-850B94F616CB}" dt="2025-02-19T18:33:34.344" v="922" actId="164"/>
          <ac:picMkLst>
            <pc:docMk/>
            <pc:sldMk cId="4227259215" sldId="257"/>
            <ac:picMk id="10" creationId="{B8A442B0-EE9C-4958-8508-81390AA4884D}"/>
          </ac:picMkLst>
        </pc:picChg>
        <pc:picChg chg="add mod topLvl modCrop">
          <ac:chgData name="ANNA MARIA VAIRA" userId="07571697-e96e-4085-b98c-c13b660e5005" providerId="ADAL" clId="{C630031A-33E5-4A8B-9E15-850B94F616CB}" dt="2025-02-19T18:33:34.344" v="922" actId="164"/>
          <ac:picMkLst>
            <pc:docMk/>
            <pc:sldMk cId="4227259215" sldId="257"/>
            <ac:picMk id="11" creationId="{20A32C01-C7EF-4C8B-BFBC-B93809DC7D67}"/>
          </ac:picMkLst>
        </pc:picChg>
        <pc:picChg chg="add mod topLvl modCrop">
          <ac:chgData name="ANNA MARIA VAIRA" userId="07571697-e96e-4085-b98c-c13b660e5005" providerId="ADAL" clId="{C630031A-33E5-4A8B-9E15-850B94F616CB}" dt="2025-02-19T18:33:34.344" v="922" actId="164"/>
          <ac:picMkLst>
            <pc:docMk/>
            <pc:sldMk cId="4227259215" sldId="257"/>
            <ac:picMk id="12" creationId="{F1D913C1-57D4-47B5-8D2F-AA429BA1BAE7}"/>
          </ac:picMkLst>
        </pc:picChg>
        <pc:picChg chg="add del mod">
          <ac:chgData name="ANNA MARIA VAIRA" userId="07571697-e96e-4085-b98c-c13b660e5005" providerId="ADAL" clId="{C630031A-33E5-4A8B-9E15-850B94F616CB}" dt="2025-02-19T18:18:26.856" v="502" actId="478"/>
          <ac:picMkLst>
            <pc:docMk/>
            <pc:sldMk cId="4227259215" sldId="257"/>
            <ac:picMk id="13" creationId="{527D8E0B-CB93-4314-9A6C-80A4E2C3D9A4}"/>
          </ac:picMkLst>
        </pc:picChg>
        <pc:picChg chg="add mod topLvl modCrop">
          <ac:chgData name="ANNA MARIA VAIRA" userId="07571697-e96e-4085-b98c-c13b660e5005" providerId="ADAL" clId="{C630031A-33E5-4A8B-9E15-850B94F616CB}" dt="2025-02-19T18:33:34.344" v="922" actId="164"/>
          <ac:picMkLst>
            <pc:docMk/>
            <pc:sldMk cId="4227259215" sldId="257"/>
            <ac:picMk id="14" creationId="{DB1660EF-6A50-40B5-BEDA-02526F4EA0B4}"/>
          </ac:picMkLst>
        </pc:picChg>
        <pc:picChg chg="add mod topLvl modCrop">
          <ac:chgData name="ANNA MARIA VAIRA" userId="07571697-e96e-4085-b98c-c13b660e5005" providerId="ADAL" clId="{C630031A-33E5-4A8B-9E15-850B94F616CB}" dt="2025-02-19T18:33:34.344" v="922" actId="164"/>
          <ac:picMkLst>
            <pc:docMk/>
            <pc:sldMk cId="4227259215" sldId="257"/>
            <ac:picMk id="15" creationId="{2712663D-9E0E-4B2D-9A96-D77BC88D0218}"/>
          </ac:picMkLst>
        </pc:picChg>
        <pc:picChg chg="add mod topLvl modCrop">
          <ac:chgData name="ANNA MARIA VAIRA" userId="07571697-e96e-4085-b98c-c13b660e5005" providerId="ADAL" clId="{C630031A-33E5-4A8B-9E15-850B94F616CB}" dt="2025-02-19T18:33:34.344" v="922" actId="164"/>
          <ac:picMkLst>
            <pc:docMk/>
            <pc:sldMk cId="4227259215" sldId="257"/>
            <ac:picMk id="16" creationId="{08A4D715-D7B1-490F-836D-6AE60F4CF561}"/>
          </ac:picMkLst>
        </pc:picChg>
      </pc:sldChg>
      <pc:sldChg chg="addSp delSp modSp add del">
        <pc:chgData name="ANNA MARIA VAIRA" userId="07571697-e96e-4085-b98c-c13b660e5005" providerId="ADAL" clId="{C630031A-33E5-4A8B-9E15-850B94F616CB}" dt="2025-02-19T18:43:34.117" v="1059" actId="2696"/>
        <pc:sldMkLst>
          <pc:docMk/>
          <pc:sldMk cId="1469423406" sldId="258"/>
        </pc:sldMkLst>
        <pc:spChg chg="del">
          <ac:chgData name="ANNA MARIA VAIRA" userId="07571697-e96e-4085-b98c-c13b660e5005" providerId="ADAL" clId="{C630031A-33E5-4A8B-9E15-850B94F616CB}" dt="2025-02-19T18:12:23.492" v="51" actId="478"/>
          <ac:spMkLst>
            <pc:docMk/>
            <pc:sldMk cId="1469423406" sldId="258"/>
            <ac:spMk id="2" creationId="{6832FFAF-EFB4-415B-A927-F8F18D8701B1}"/>
          </ac:spMkLst>
        </pc:spChg>
        <pc:spChg chg="del">
          <ac:chgData name="ANNA MARIA VAIRA" userId="07571697-e96e-4085-b98c-c13b660e5005" providerId="ADAL" clId="{C630031A-33E5-4A8B-9E15-850B94F616CB}" dt="2025-02-19T18:12:21.542" v="50" actId="478"/>
          <ac:spMkLst>
            <pc:docMk/>
            <pc:sldMk cId="1469423406" sldId="258"/>
            <ac:spMk id="3" creationId="{7FA47D69-7717-493E-946A-53D6307596E4}"/>
          </ac:spMkLst>
        </pc:spChg>
        <pc:picChg chg="add mod">
          <ac:chgData name="ANNA MARIA VAIRA" userId="07571697-e96e-4085-b98c-c13b660e5005" providerId="ADAL" clId="{C630031A-33E5-4A8B-9E15-850B94F616CB}" dt="2025-02-19T18:12:38.278" v="52" actId="931"/>
          <ac:picMkLst>
            <pc:docMk/>
            <pc:sldMk cId="1469423406" sldId="258"/>
            <ac:picMk id="5" creationId="{B6C46F35-5D14-4173-98AB-10A0864F2F95}"/>
          </ac:picMkLst>
        </pc:picChg>
      </pc:sldChg>
      <pc:sldChg chg="add del">
        <pc:chgData name="ANNA MARIA VAIRA" userId="07571697-e96e-4085-b98c-c13b660e5005" providerId="ADAL" clId="{C630031A-33E5-4A8B-9E15-850B94F616CB}" dt="2025-02-19T18:43:34.117" v="1058" actId="2696"/>
        <pc:sldMkLst>
          <pc:docMk/>
          <pc:sldMk cId="1923681085" sldId="259"/>
        </pc:sldMkLst>
      </pc:sldChg>
      <pc:sldChg chg="addSp delSp add del">
        <pc:chgData name="ANNA MARIA VAIRA" userId="07571697-e96e-4085-b98c-c13b660e5005" providerId="ADAL" clId="{C630031A-33E5-4A8B-9E15-850B94F616CB}" dt="2025-02-19T18:43:34.117" v="1057" actId="2696"/>
        <pc:sldMkLst>
          <pc:docMk/>
          <pc:sldMk cId="3644972501" sldId="260"/>
        </pc:sldMkLst>
        <pc:picChg chg="add">
          <ac:chgData name="ANNA MARIA VAIRA" userId="07571697-e96e-4085-b98c-c13b660e5005" providerId="ADAL" clId="{C630031A-33E5-4A8B-9E15-850B94F616CB}" dt="2025-02-19T18:26:39.585" v="842"/>
          <ac:picMkLst>
            <pc:docMk/>
            <pc:sldMk cId="3644972501" sldId="260"/>
            <ac:picMk id="3" creationId="{8AFBC575-9896-4D17-86B4-82CF03AB4FD6}"/>
          </ac:picMkLst>
        </pc:picChg>
        <pc:picChg chg="add">
          <ac:chgData name="ANNA MARIA VAIRA" userId="07571697-e96e-4085-b98c-c13b660e5005" providerId="ADAL" clId="{C630031A-33E5-4A8B-9E15-850B94F616CB}" dt="2025-02-19T18:26:39.585" v="842"/>
          <ac:picMkLst>
            <pc:docMk/>
            <pc:sldMk cId="3644972501" sldId="260"/>
            <ac:picMk id="4" creationId="{D64B3D93-2714-42A8-B00D-BA6792D8AEE6}"/>
          </ac:picMkLst>
        </pc:picChg>
        <pc:picChg chg="del">
          <ac:chgData name="ANNA MARIA VAIRA" userId="07571697-e96e-4085-b98c-c13b660e5005" providerId="ADAL" clId="{C630031A-33E5-4A8B-9E15-850B94F616CB}" dt="2025-02-19T18:26:37.323" v="841" actId="478"/>
          <ac:picMkLst>
            <pc:docMk/>
            <pc:sldMk cId="3644972501" sldId="260"/>
            <ac:picMk id="5" creationId="{B6C46F35-5D14-4173-98AB-10A0864F2F95}"/>
          </ac:picMkLst>
        </pc:picChg>
        <pc:picChg chg="add">
          <ac:chgData name="ANNA MARIA VAIRA" userId="07571697-e96e-4085-b98c-c13b660e5005" providerId="ADAL" clId="{C630031A-33E5-4A8B-9E15-850B94F616CB}" dt="2025-02-19T18:26:39.585" v="842"/>
          <ac:picMkLst>
            <pc:docMk/>
            <pc:sldMk cId="3644972501" sldId="260"/>
            <ac:picMk id="6" creationId="{1628EAF0-C648-4FEE-9DCC-3EFC7E36E7AD}"/>
          </ac:picMkLst>
        </pc:picChg>
        <pc:picChg chg="add">
          <ac:chgData name="ANNA MARIA VAIRA" userId="07571697-e96e-4085-b98c-c13b660e5005" providerId="ADAL" clId="{C630031A-33E5-4A8B-9E15-850B94F616CB}" dt="2025-02-19T18:26:39.585" v="842"/>
          <ac:picMkLst>
            <pc:docMk/>
            <pc:sldMk cId="3644972501" sldId="260"/>
            <ac:picMk id="7" creationId="{D9B34223-76F3-48D7-8213-5C268C76109C}"/>
          </ac:picMkLst>
        </pc:picChg>
        <pc:picChg chg="add">
          <ac:chgData name="ANNA MARIA VAIRA" userId="07571697-e96e-4085-b98c-c13b660e5005" providerId="ADAL" clId="{C630031A-33E5-4A8B-9E15-850B94F616CB}" dt="2025-02-19T18:26:39.585" v="842"/>
          <ac:picMkLst>
            <pc:docMk/>
            <pc:sldMk cId="3644972501" sldId="260"/>
            <ac:picMk id="8" creationId="{9D49D119-23EF-4C44-9CFF-74D677D75494}"/>
          </ac:picMkLst>
        </pc:picChg>
        <pc:picChg chg="add">
          <ac:chgData name="ANNA MARIA VAIRA" userId="07571697-e96e-4085-b98c-c13b660e5005" providerId="ADAL" clId="{C630031A-33E5-4A8B-9E15-850B94F616CB}" dt="2025-02-19T18:26:39.585" v="842"/>
          <ac:picMkLst>
            <pc:docMk/>
            <pc:sldMk cId="3644972501" sldId="260"/>
            <ac:picMk id="9" creationId="{F91D2863-8609-407E-8624-276F9A1129D5}"/>
          </ac:picMkLst>
        </pc:picChg>
        <pc:picChg chg="add">
          <ac:chgData name="ANNA MARIA VAIRA" userId="07571697-e96e-4085-b98c-c13b660e5005" providerId="ADAL" clId="{C630031A-33E5-4A8B-9E15-850B94F616CB}" dt="2025-02-19T18:26:39.585" v="842"/>
          <ac:picMkLst>
            <pc:docMk/>
            <pc:sldMk cId="3644972501" sldId="260"/>
            <ac:picMk id="10" creationId="{3F4045C0-B25B-4B3B-95D3-75B5FBB227E2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9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9613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9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4374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9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79532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9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46769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9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4005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9/0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8271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9/02/20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8119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9/02/20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4164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9/02/20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125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9/0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7476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4238F-8988-4C26-8A3B-D1F8E61227D0}" type="datetimeFigureOut">
              <a:rPr lang="it-IT" smtClean="0"/>
              <a:t>19/0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0871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B4238F-8988-4C26-8A3B-D1F8E61227D0}" type="datetimeFigureOut">
              <a:rPr lang="it-IT" smtClean="0"/>
              <a:t>19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86B86EA-3355-412E-BB79-E4FB5154662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1003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0862031-F6F8-CD8A-1223-FCD978ADAEE8}"/>
              </a:ext>
            </a:extLst>
          </p:cNvPr>
          <p:cNvSpPr txBox="1"/>
          <p:nvPr/>
        </p:nvSpPr>
        <p:spPr>
          <a:xfrm>
            <a:off x="255657" y="512531"/>
            <a:ext cx="6247379" cy="55399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sz="1000" b="1" err="1">
                <a:latin typeface="Times New Roman"/>
                <a:cs typeface="Times New Roman"/>
              </a:rPr>
              <a:t>Supplementary</a:t>
            </a:r>
            <a:r>
              <a:rPr lang="it-IT" sz="1000" b="1">
                <a:latin typeface="Times New Roman"/>
                <a:cs typeface="Times New Roman"/>
              </a:rPr>
              <a:t> Figure S1</a:t>
            </a:r>
            <a:r>
              <a:rPr lang="it-IT" sz="1000">
                <a:latin typeface="Times New Roman"/>
                <a:cs typeface="Times New Roman"/>
              </a:rPr>
              <a:t>. RT-PCR </a:t>
            </a:r>
            <a:r>
              <a:rPr lang="it-IT" sz="1000" err="1">
                <a:latin typeface="Times New Roman"/>
                <a:cs typeface="Times New Roman"/>
              </a:rPr>
              <a:t>validation</a:t>
            </a:r>
            <a:r>
              <a:rPr lang="it-IT" sz="1000">
                <a:latin typeface="Times New Roman"/>
                <a:cs typeface="Times New Roman"/>
              </a:rPr>
              <a:t> with </a:t>
            </a:r>
            <a:r>
              <a:rPr lang="it-IT" sz="1000" err="1">
                <a:latin typeface="Times New Roman"/>
                <a:cs typeface="Times New Roman"/>
              </a:rPr>
              <a:t>specific</a:t>
            </a:r>
            <a:r>
              <a:rPr lang="it-IT" sz="1000">
                <a:latin typeface="Times New Roman"/>
                <a:cs typeface="Times New Roman"/>
              </a:rPr>
              <a:t> primers of </a:t>
            </a:r>
            <a:r>
              <a:rPr lang="it-IT" sz="1000" err="1">
                <a:latin typeface="Times New Roman"/>
                <a:cs typeface="Times New Roman"/>
              </a:rPr>
              <a:t>viruses</a:t>
            </a:r>
            <a:r>
              <a:rPr lang="it-IT" sz="1000">
                <a:latin typeface="Times New Roman"/>
                <a:cs typeface="Times New Roman"/>
              </a:rPr>
              <a:t> </a:t>
            </a:r>
            <a:r>
              <a:rPr lang="it-IT" sz="1000" err="1">
                <a:latin typeface="Times New Roman"/>
                <a:cs typeface="Times New Roman"/>
              </a:rPr>
              <a:t>previously</a:t>
            </a:r>
            <a:r>
              <a:rPr lang="it-IT" sz="1000">
                <a:latin typeface="Times New Roman"/>
                <a:cs typeface="Times New Roman"/>
              </a:rPr>
              <a:t> </a:t>
            </a:r>
            <a:r>
              <a:rPr lang="it-IT" sz="1000" err="1">
                <a:latin typeface="Times New Roman"/>
                <a:cs typeface="Times New Roman"/>
              </a:rPr>
              <a:t>identified</a:t>
            </a:r>
            <a:r>
              <a:rPr lang="it-IT" sz="1000">
                <a:latin typeface="Times New Roman"/>
                <a:cs typeface="Times New Roman"/>
              </a:rPr>
              <a:t> by RNA-</a:t>
            </a:r>
            <a:r>
              <a:rPr lang="it-IT" sz="1000" err="1">
                <a:latin typeface="Times New Roman"/>
                <a:cs typeface="Times New Roman"/>
              </a:rPr>
              <a:t>seq</a:t>
            </a:r>
            <a:r>
              <a:rPr lang="it-IT" sz="1000">
                <a:latin typeface="Times New Roman"/>
                <a:cs typeface="Times New Roman"/>
              </a:rPr>
              <a:t> </a:t>
            </a:r>
            <a:r>
              <a:rPr lang="it-IT" sz="1000" err="1">
                <a:latin typeface="Times New Roman"/>
                <a:cs typeface="Times New Roman"/>
              </a:rPr>
              <a:t>analysis</a:t>
            </a:r>
            <a:r>
              <a:rPr lang="it-IT" sz="1000">
                <a:latin typeface="Times New Roman"/>
                <a:cs typeface="Times New Roman"/>
              </a:rPr>
              <a:t>. Fr2, Fr6, Fr8, Fr14, Fr20, Fr21 are the </a:t>
            </a:r>
            <a:r>
              <a:rPr lang="it-IT" sz="1000" err="1">
                <a:latin typeface="Times New Roman"/>
                <a:cs typeface="Times New Roman"/>
              </a:rPr>
              <a:t>six</a:t>
            </a:r>
            <a:r>
              <a:rPr lang="it-IT" sz="1000">
                <a:latin typeface="Times New Roman"/>
                <a:cs typeface="Times New Roman"/>
              </a:rPr>
              <a:t> </a:t>
            </a:r>
            <a:r>
              <a:rPr lang="it-IT" sz="1000" err="1">
                <a:latin typeface="Times New Roman"/>
                <a:cs typeface="Times New Roman"/>
              </a:rPr>
              <a:t>individual</a:t>
            </a:r>
            <a:r>
              <a:rPr lang="it-IT" sz="1000">
                <a:latin typeface="Times New Roman"/>
                <a:cs typeface="Times New Roman"/>
              </a:rPr>
              <a:t> </a:t>
            </a:r>
            <a:r>
              <a:rPr lang="it-IT" sz="1000" err="1">
                <a:latin typeface="Times New Roman"/>
                <a:cs typeface="Times New Roman"/>
              </a:rPr>
              <a:t>necrotic</a:t>
            </a:r>
            <a:r>
              <a:rPr lang="it-IT" sz="1000">
                <a:latin typeface="Times New Roman"/>
                <a:cs typeface="Times New Roman"/>
              </a:rPr>
              <a:t> </a:t>
            </a:r>
            <a:r>
              <a:rPr lang="it-IT" sz="1000" err="1">
                <a:latin typeface="Times New Roman"/>
                <a:cs typeface="Times New Roman"/>
              </a:rPr>
              <a:t>freesia</a:t>
            </a:r>
            <a:r>
              <a:rPr lang="it-IT" sz="1000">
                <a:latin typeface="Times New Roman"/>
                <a:cs typeface="Times New Roman"/>
              </a:rPr>
              <a:t> </a:t>
            </a:r>
            <a:r>
              <a:rPr lang="it-IT" sz="1000" err="1">
                <a:latin typeface="Times New Roman"/>
                <a:cs typeface="Times New Roman"/>
              </a:rPr>
              <a:t>leaves</a:t>
            </a:r>
            <a:r>
              <a:rPr lang="it-IT" sz="1000">
                <a:latin typeface="Times New Roman"/>
                <a:cs typeface="Times New Roman"/>
              </a:rPr>
              <a:t> samples </a:t>
            </a:r>
            <a:r>
              <a:rPr lang="it-IT" sz="1000" err="1">
                <a:latin typeface="Times New Roman"/>
                <a:cs typeface="Times New Roman"/>
              </a:rPr>
              <a:t>pooled</a:t>
            </a:r>
            <a:r>
              <a:rPr lang="it-IT" sz="1000">
                <a:latin typeface="Times New Roman"/>
                <a:cs typeface="Times New Roman"/>
              </a:rPr>
              <a:t> for the 2022 RNA-</a:t>
            </a:r>
            <a:r>
              <a:rPr lang="it-IT" sz="1000" err="1">
                <a:latin typeface="Times New Roman"/>
                <a:cs typeface="Times New Roman"/>
              </a:rPr>
              <a:t>seq</a:t>
            </a:r>
            <a:r>
              <a:rPr lang="it-IT" sz="1000">
                <a:latin typeface="Times New Roman"/>
                <a:cs typeface="Times New Roman"/>
              </a:rPr>
              <a:t> </a:t>
            </a:r>
            <a:r>
              <a:rPr lang="it-IT" sz="1000" err="1">
                <a:latin typeface="Times New Roman"/>
                <a:cs typeface="Times New Roman"/>
              </a:rPr>
              <a:t>analysis</a:t>
            </a:r>
            <a:r>
              <a:rPr lang="it-IT" sz="1000">
                <a:latin typeface="Times New Roman"/>
                <a:cs typeface="Times New Roman"/>
              </a:rPr>
              <a:t>.</a:t>
            </a:r>
            <a:endParaRPr lang="it-IT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9" name="Group 58">
            <a:extLst>
              <a:ext uri="{FF2B5EF4-FFF2-40B4-BE49-F238E27FC236}">
                <a16:creationId xmlns:a16="http://schemas.microsoft.com/office/drawing/2014/main" id="{49287315-5390-DF09-949A-A03DC4947104}"/>
              </a:ext>
            </a:extLst>
          </p:cNvPr>
          <p:cNvGrpSpPr/>
          <p:nvPr/>
        </p:nvGrpSpPr>
        <p:grpSpPr>
          <a:xfrm>
            <a:off x="273955" y="3610715"/>
            <a:ext cx="2935087" cy="1060459"/>
            <a:chOff x="551204" y="1764405"/>
            <a:chExt cx="2877796" cy="1060459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0509D62-CF7D-6AA0-6D23-D2AB6776F88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3659" t="32999" r="7672" b="40966"/>
            <a:stretch/>
          </p:blipFill>
          <p:spPr>
            <a:xfrm>
              <a:off x="603868" y="1764405"/>
              <a:ext cx="2219827" cy="1024036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B836896-7C62-3094-B580-1DF7286AB177}"/>
                </a:ext>
              </a:extLst>
            </p:cNvPr>
            <p:cNvSpPr txBox="1"/>
            <p:nvPr/>
          </p:nvSpPr>
          <p:spPr>
            <a:xfrm>
              <a:off x="551204" y="2547865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YMV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37BDE1F-9D13-F73D-9AC5-950137E54FB4}"/>
                </a:ext>
              </a:extLst>
            </p:cNvPr>
            <p:cNvSpPr txBox="1"/>
            <p:nvPr/>
          </p:nvSpPr>
          <p:spPr>
            <a:xfrm>
              <a:off x="2746421" y="2093606"/>
              <a:ext cx="68257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sz="10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- 994nt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59487048-F850-32BC-977A-6490B4BC9CAD}"/>
              </a:ext>
            </a:extLst>
          </p:cNvPr>
          <p:cNvGrpSpPr/>
          <p:nvPr/>
        </p:nvGrpSpPr>
        <p:grpSpPr>
          <a:xfrm>
            <a:off x="256503" y="4679319"/>
            <a:ext cx="2935086" cy="1056068"/>
            <a:chOff x="551204" y="2894071"/>
            <a:chExt cx="2877795" cy="1056068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E5203376-8B94-CD6D-2677-C0A4239B579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4038" t="41823" b="24463"/>
            <a:stretch/>
          </p:blipFill>
          <p:spPr>
            <a:xfrm>
              <a:off x="618185" y="2894071"/>
              <a:ext cx="2218108" cy="1024036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3371108-6244-38F4-80DD-0CD5D2685E83}"/>
                </a:ext>
              </a:extLst>
            </p:cNvPr>
            <p:cNvSpPr txBox="1"/>
            <p:nvPr/>
          </p:nvSpPr>
          <p:spPr>
            <a:xfrm>
              <a:off x="551204" y="3673140"/>
              <a:ext cx="7251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reYV-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B0B045A-D0D3-FF5B-6988-E5AFD1B127A9}"/>
                </a:ext>
              </a:extLst>
            </p:cNvPr>
            <p:cNvSpPr txBox="1"/>
            <p:nvPr/>
          </p:nvSpPr>
          <p:spPr>
            <a:xfrm>
              <a:off x="2746420" y="3223272"/>
              <a:ext cx="68257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sz="10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- 524nt</a:t>
              </a:r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32A559C6-3781-4D7C-88C6-2FEDBAFB4544}"/>
              </a:ext>
            </a:extLst>
          </p:cNvPr>
          <p:cNvGrpSpPr/>
          <p:nvPr/>
        </p:nvGrpSpPr>
        <p:grpSpPr>
          <a:xfrm>
            <a:off x="3260261" y="2532858"/>
            <a:ext cx="3765878" cy="3223304"/>
            <a:chOff x="555960" y="4060673"/>
            <a:chExt cx="3692371" cy="3223304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82AC12B8-B57E-D39C-E5C4-A8BCEEF1A2A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52729" t="57435" r="2547" b="7910"/>
            <a:stretch/>
          </p:blipFill>
          <p:spPr>
            <a:xfrm>
              <a:off x="618184" y="4060673"/>
              <a:ext cx="2203801" cy="1034688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2C04B19-62FE-8D50-8ED8-7BEE96168DDB}"/>
                </a:ext>
              </a:extLst>
            </p:cNvPr>
            <p:cNvSpPr txBox="1"/>
            <p:nvPr/>
          </p:nvSpPr>
          <p:spPr>
            <a:xfrm>
              <a:off x="574888" y="4871041"/>
              <a:ext cx="11644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reKV-1 RNA2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2D71220-06A6-9996-0869-C5A0A56A817A}"/>
                </a:ext>
              </a:extLst>
            </p:cNvPr>
            <p:cNvSpPr txBox="1"/>
            <p:nvPr/>
          </p:nvSpPr>
          <p:spPr>
            <a:xfrm>
              <a:off x="2746419" y="4396772"/>
              <a:ext cx="68257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sz="10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- 369nt</a:t>
              </a:r>
            </a:p>
          </p:txBody>
        </p: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E7C0F73C-B52D-0451-737E-8B7F248ADD3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t="41203" r="50977" b="24288"/>
            <a:stretch/>
          </p:blipFill>
          <p:spPr>
            <a:xfrm>
              <a:off x="612162" y="5143873"/>
              <a:ext cx="2203801" cy="988587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76006291-45A5-CBE6-751C-BDF2C0F92C2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48653" t="39186" r="1599" b="23966"/>
            <a:stretch/>
          </p:blipFill>
          <p:spPr>
            <a:xfrm>
              <a:off x="597493" y="6176666"/>
              <a:ext cx="2239651" cy="1057176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1AE4D69-D33C-F2BD-FD39-AD137649A941}"/>
                </a:ext>
              </a:extLst>
            </p:cNvPr>
            <p:cNvSpPr txBox="1"/>
            <p:nvPr/>
          </p:nvSpPr>
          <p:spPr>
            <a:xfrm>
              <a:off x="572947" y="5899666"/>
              <a:ext cx="11644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reKV-1 RNA3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91C00AD-AF93-068E-48F4-AB03CA185C55}"/>
                </a:ext>
              </a:extLst>
            </p:cNvPr>
            <p:cNvSpPr txBox="1"/>
            <p:nvPr/>
          </p:nvSpPr>
          <p:spPr>
            <a:xfrm>
              <a:off x="555960" y="7006978"/>
              <a:ext cx="11644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reKV-1 RNA4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3A9CC97-5055-52A7-3EAA-73E81C13128E}"/>
                </a:ext>
              </a:extLst>
            </p:cNvPr>
            <p:cNvSpPr txBox="1"/>
            <p:nvPr/>
          </p:nvSpPr>
          <p:spPr>
            <a:xfrm>
              <a:off x="2745192" y="6425094"/>
              <a:ext cx="68257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sz="10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- 845nt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7C5D0FA-9335-DBF2-E6BA-33C3F07EF4E0}"/>
                </a:ext>
              </a:extLst>
            </p:cNvPr>
            <p:cNvSpPr txBox="1"/>
            <p:nvPr/>
          </p:nvSpPr>
          <p:spPr>
            <a:xfrm>
              <a:off x="2764662" y="6809931"/>
              <a:ext cx="1483669" cy="400110"/>
            </a:xfrm>
            <a:prstGeom prst="rect">
              <a:avLst/>
            </a:prstGeom>
            <a:noFill/>
          </p:spPr>
          <p:txBody>
            <a:bodyPr wrap="square" lIns="91440" tIns="45720" rIns="91440" bIns="45720" anchor="t">
              <a:spAutoFit/>
            </a:bodyPr>
            <a:lstStyle/>
            <a:p>
              <a:r>
                <a:rPr lang="it-IT" sz="1000" b="1">
                  <a:latin typeface="Times New Roman"/>
                  <a:cs typeface="Times New Roman"/>
                </a:rPr>
                <a:t>368nt defective RNA</a:t>
              </a:r>
              <a:endParaRPr lang="it-IT"/>
            </a:p>
            <a:p>
              <a:endParaRPr lang="it-IT"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96CE538-C088-6F4D-3F21-6DF392D691F3}"/>
                </a:ext>
              </a:extLst>
            </p:cNvPr>
            <p:cNvSpPr txBox="1"/>
            <p:nvPr/>
          </p:nvSpPr>
          <p:spPr>
            <a:xfrm>
              <a:off x="2746419" y="5633117"/>
              <a:ext cx="68257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sz="10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- 465nt</a:t>
              </a:r>
            </a:p>
          </p:txBody>
        </p: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7BDA1731-57F1-4948-C378-C3B57414EF4F}"/>
              </a:ext>
            </a:extLst>
          </p:cNvPr>
          <p:cNvGrpSpPr/>
          <p:nvPr/>
        </p:nvGrpSpPr>
        <p:grpSpPr>
          <a:xfrm>
            <a:off x="259058" y="1378591"/>
            <a:ext cx="2932531" cy="1154267"/>
            <a:chOff x="553708" y="1578370"/>
            <a:chExt cx="2875290" cy="1154267"/>
          </a:xfrm>
        </p:grpSpPr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B6AC2AB8-5AAA-2871-9152-5A6FD3148F0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32425" y="1805799"/>
              <a:ext cx="2203801" cy="878326"/>
            </a:xfrm>
            <a:prstGeom prst="rect">
              <a:avLst/>
            </a:prstGeom>
          </p:spPr>
        </p:pic>
        <p:sp>
          <p:nvSpPr>
            <p:cNvPr id="8" name="Rettangolo 2">
              <a:extLst>
                <a:ext uri="{FF2B5EF4-FFF2-40B4-BE49-F238E27FC236}">
                  <a16:creationId xmlns:a16="http://schemas.microsoft.com/office/drawing/2014/main" id="{7A9EAF35-B2A2-6828-CD2A-3552D833A1FA}"/>
                </a:ext>
              </a:extLst>
            </p:cNvPr>
            <p:cNvSpPr/>
            <p:nvPr/>
          </p:nvSpPr>
          <p:spPr>
            <a:xfrm>
              <a:off x="573874" y="1578370"/>
              <a:ext cx="2406775" cy="26606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US" sz="9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900" b="1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r2   Fr6    Fr8  Fr14  Fr20  Fr21    </a:t>
              </a:r>
              <a:r>
                <a:rPr lang="en-US" sz="900" b="1" dirty="0" err="1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t</a:t>
              </a:r>
              <a:r>
                <a:rPr lang="en-US" sz="900" b="1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    1kb</a:t>
              </a:r>
              <a:endParaRPr lang="it-IT" sz="900" b="1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48F6D8C-F0A1-6872-58F7-ED1498FD9FBE}"/>
                </a:ext>
              </a:extLst>
            </p:cNvPr>
            <p:cNvSpPr txBox="1"/>
            <p:nvPr/>
          </p:nvSpPr>
          <p:spPr>
            <a:xfrm>
              <a:off x="2746419" y="2044528"/>
              <a:ext cx="68257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sz="10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- 329nt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227031A-962F-0E90-BABA-264231932C86}"/>
                </a:ext>
              </a:extLst>
            </p:cNvPr>
            <p:cNvSpPr txBox="1"/>
            <p:nvPr/>
          </p:nvSpPr>
          <p:spPr>
            <a:xfrm>
              <a:off x="553708" y="2455638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reMV</a:t>
              </a:r>
              <a:endParaRPr lang="it-IT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id="{FB4A93D2-DEB2-C248-D05D-802B984FDB0D}"/>
              </a:ext>
            </a:extLst>
          </p:cNvPr>
          <p:cNvGrpSpPr/>
          <p:nvPr/>
        </p:nvGrpSpPr>
        <p:grpSpPr>
          <a:xfrm>
            <a:off x="3277586" y="1365447"/>
            <a:ext cx="2948219" cy="1146222"/>
            <a:chOff x="3612582" y="2468429"/>
            <a:chExt cx="2890672" cy="1146222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ADB3B578-28F4-DA08-0841-3E7C0BA62E6A}"/>
                </a:ext>
              </a:extLst>
            </p:cNvPr>
            <p:cNvGrpSpPr/>
            <p:nvPr/>
          </p:nvGrpSpPr>
          <p:grpSpPr>
            <a:xfrm>
              <a:off x="3612582" y="2682984"/>
              <a:ext cx="2890672" cy="931667"/>
              <a:chOff x="551204" y="7815386"/>
              <a:chExt cx="2890672" cy="931667"/>
            </a:xfrm>
          </p:grpSpPr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8536A14B-7C7D-23E7-A4A2-19BC5AD4C5C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rcRect l="1599" t="45805" r="51263" b="30274"/>
              <a:stretch/>
            </p:blipFill>
            <p:spPr>
              <a:xfrm>
                <a:off x="611599" y="7815386"/>
                <a:ext cx="2203802" cy="904344"/>
              </a:xfrm>
              <a:prstGeom prst="rect">
                <a:avLst/>
              </a:prstGeom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6D3BEDF8-325D-210C-7203-D7EB3F582210}"/>
                  </a:ext>
                </a:extLst>
              </p:cNvPr>
              <p:cNvSpPr txBox="1"/>
              <p:nvPr/>
            </p:nvSpPr>
            <p:spPr>
              <a:xfrm>
                <a:off x="551204" y="8470054"/>
                <a:ext cx="11644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reKV-1 RNA1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02391B16-1323-DD6C-E369-E23F51DE6A5A}"/>
                  </a:ext>
                </a:extLst>
              </p:cNvPr>
              <p:cNvSpPr txBox="1"/>
              <p:nvPr/>
            </p:nvSpPr>
            <p:spPr>
              <a:xfrm>
                <a:off x="2759297" y="8230727"/>
                <a:ext cx="682579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it-IT" sz="10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 701nt</a:t>
                </a:r>
              </a:p>
            </p:txBody>
          </p:sp>
        </p:grpSp>
        <p:sp>
          <p:nvSpPr>
            <p:cNvPr id="70" name="Rettangolo 2">
              <a:extLst>
                <a:ext uri="{FF2B5EF4-FFF2-40B4-BE49-F238E27FC236}">
                  <a16:creationId xmlns:a16="http://schemas.microsoft.com/office/drawing/2014/main" id="{F25B2E67-6A62-8B35-4906-8D758DC91A41}"/>
                </a:ext>
              </a:extLst>
            </p:cNvPr>
            <p:cNvSpPr/>
            <p:nvPr/>
          </p:nvSpPr>
          <p:spPr>
            <a:xfrm>
              <a:off x="3612582" y="2468429"/>
              <a:ext cx="2489733" cy="26606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US" sz="9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900" b="1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r2   Fr6   Fr8   Fr14   Fr20  Fr21   </a:t>
              </a:r>
              <a:r>
                <a:rPr lang="en-US" sz="900" b="1" dirty="0" err="1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t</a:t>
              </a:r>
              <a:r>
                <a:rPr lang="en-US" sz="900" b="1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  1kb</a:t>
              </a:r>
              <a:endParaRPr lang="it-IT" sz="900" b="1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" name="Gruppo 9">
            <a:extLst>
              <a:ext uri="{FF2B5EF4-FFF2-40B4-BE49-F238E27FC236}">
                <a16:creationId xmlns:a16="http://schemas.microsoft.com/office/drawing/2014/main" id="{244D0B83-1B6F-4A56-815B-F8EE52E365EA}"/>
              </a:ext>
            </a:extLst>
          </p:cNvPr>
          <p:cNvGrpSpPr/>
          <p:nvPr/>
        </p:nvGrpSpPr>
        <p:grpSpPr>
          <a:xfrm>
            <a:off x="295796" y="2545735"/>
            <a:ext cx="2862859" cy="1013729"/>
            <a:chOff x="295796" y="2545735"/>
            <a:chExt cx="2862859" cy="1013729"/>
          </a:xfrm>
        </p:grpSpPr>
        <p:pic>
          <p:nvPicPr>
            <p:cNvPr id="42" name="Immagine 41">
              <a:extLst>
                <a:ext uri="{FF2B5EF4-FFF2-40B4-BE49-F238E27FC236}">
                  <a16:creationId xmlns:a16="http://schemas.microsoft.com/office/drawing/2014/main" id="{95DBC3A1-1E1B-4B61-B2B5-9AFA11FC0E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13" t="31224" r="86921" b="39110"/>
            <a:stretch/>
          </p:blipFill>
          <p:spPr>
            <a:xfrm>
              <a:off x="334237" y="2545735"/>
              <a:ext cx="313952" cy="1008000"/>
            </a:xfrm>
            <a:prstGeom prst="rect">
              <a:avLst/>
            </a:prstGeom>
          </p:spPr>
        </p:pic>
        <p:pic>
          <p:nvPicPr>
            <p:cNvPr id="43" name="Immagine 42">
              <a:extLst>
                <a:ext uri="{FF2B5EF4-FFF2-40B4-BE49-F238E27FC236}">
                  <a16:creationId xmlns:a16="http://schemas.microsoft.com/office/drawing/2014/main" id="{918ABB40-701E-4E63-9B90-B1C5D682A8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047" t="31224" r="68381" b="39110"/>
            <a:stretch/>
          </p:blipFill>
          <p:spPr>
            <a:xfrm>
              <a:off x="645331" y="2545735"/>
              <a:ext cx="253273" cy="1008000"/>
            </a:xfrm>
            <a:prstGeom prst="rect">
              <a:avLst/>
            </a:prstGeom>
          </p:spPr>
        </p:pic>
        <p:pic>
          <p:nvPicPr>
            <p:cNvPr id="47" name="Immagine 46">
              <a:extLst>
                <a:ext uri="{FF2B5EF4-FFF2-40B4-BE49-F238E27FC236}">
                  <a16:creationId xmlns:a16="http://schemas.microsoft.com/office/drawing/2014/main" id="{91641B11-47CA-4B9E-81FE-73CF7F5A42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180" t="33535" r="44205" b="36799"/>
            <a:stretch/>
          </p:blipFill>
          <p:spPr>
            <a:xfrm>
              <a:off x="2286082" y="2545735"/>
              <a:ext cx="311097" cy="1008000"/>
            </a:xfrm>
            <a:prstGeom prst="rect">
              <a:avLst/>
            </a:prstGeom>
          </p:spPr>
        </p:pic>
        <p:pic>
          <p:nvPicPr>
            <p:cNvPr id="48" name="Immagine 47">
              <a:extLst>
                <a:ext uri="{FF2B5EF4-FFF2-40B4-BE49-F238E27FC236}">
                  <a16:creationId xmlns:a16="http://schemas.microsoft.com/office/drawing/2014/main" id="{F18D4883-9867-48FA-AA1B-BE58A5D69E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107" t="33535" r="32983" b="36799"/>
            <a:stretch/>
          </p:blipFill>
          <p:spPr>
            <a:xfrm>
              <a:off x="2014071" y="2545735"/>
              <a:ext cx="272013" cy="1008000"/>
            </a:xfrm>
            <a:prstGeom prst="rect">
              <a:avLst/>
            </a:prstGeom>
          </p:spPr>
        </p:pic>
        <p:sp>
          <p:nvSpPr>
            <p:cNvPr id="3" name="CasellaDiTesto 2">
              <a:extLst>
                <a:ext uri="{FF2B5EF4-FFF2-40B4-BE49-F238E27FC236}">
                  <a16:creationId xmlns:a16="http://schemas.microsoft.com/office/drawing/2014/main" id="{8BF14B3F-49A8-4CBC-9847-E27A53D7515D}"/>
                </a:ext>
              </a:extLst>
            </p:cNvPr>
            <p:cNvSpPr txBox="1"/>
            <p:nvPr/>
          </p:nvSpPr>
          <p:spPr>
            <a:xfrm>
              <a:off x="295796" y="3282465"/>
              <a:ext cx="5854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reSV</a:t>
              </a:r>
              <a:endParaRPr lang="it-IT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824E08DE-28DA-43E3-BBCA-E04AE73F9FC0}"/>
                </a:ext>
              </a:extLst>
            </p:cNvPr>
            <p:cNvSpPr txBox="1"/>
            <p:nvPr/>
          </p:nvSpPr>
          <p:spPr>
            <a:xfrm>
              <a:off x="2528354" y="2868957"/>
              <a:ext cx="63030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1325nt</a:t>
              </a:r>
            </a:p>
          </p:txBody>
        </p:sp>
        <p:pic>
          <p:nvPicPr>
            <p:cNvPr id="45" name="Immagine 44">
              <a:extLst>
                <a:ext uri="{FF2B5EF4-FFF2-40B4-BE49-F238E27FC236}">
                  <a16:creationId xmlns:a16="http://schemas.microsoft.com/office/drawing/2014/main" id="{C8F62B0F-0F0D-410A-A03C-F8BD5681B9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210" t="31224" r="26821" b="39110"/>
            <a:stretch/>
          </p:blipFill>
          <p:spPr>
            <a:xfrm>
              <a:off x="1148495" y="2545735"/>
              <a:ext cx="275332" cy="1008000"/>
            </a:xfrm>
            <a:prstGeom prst="rect">
              <a:avLst/>
            </a:prstGeom>
          </p:spPr>
        </p:pic>
        <p:pic>
          <p:nvPicPr>
            <p:cNvPr id="46" name="Immagine 45">
              <a:extLst>
                <a:ext uri="{FF2B5EF4-FFF2-40B4-BE49-F238E27FC236}">
                  <a16:creationId xmlns:a16="http://schemas.microsoft.com/office/drawing/2014/main" id="{786DAA47-4B9E-403F-9046-94B4C045C5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32" t="33535" r="55240" b="36799"/>
            <a:stretch/>
          </p:blipFill>
          <p:spPr>
            <a:xfrm>
              <a:off x="1418167" y="2545735"/>
              <a:ext cx="633184" cy="1008000"/>
            </a:xfrm>
            <a:prstGeom prst="rect">
              <a:avLst/>
            </a:prstGeom>
          </p:spPr>
        </p:pic>
        <p:pic>
          <p:nvPicPr>
            <p:cNvPr id="44" name="Immagine 43">
              <a:extLst>
                <a:ext uri="{FF2B5EF4-FFF2-40B4-BE49-F238E27FC236}">
                  <a16:creationId xmlns:a16="http://schemas.microsoft.com/office/drawing/2014/main" id="{F9192054-B5D4-4679-AD5F-7E719F79D0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015" t="31224" r="58015" b="39110"/>
            <a:stretch/>
          </p:blipFill>
          <p:spPr>
            <a:xfrm>
              <a:off x="897339" y="2545735"/>
              <a:ext cx="275332" cy="1008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89454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D3896766B253BF4C954DE14C4319FB08" ma:contentTypeVersion="11" ma:contentTypeDescription="Creare un nuovo documento." ma:contentTypeScope="" ma:versionID="55f3245f08a521eb9542d035c68db22e">
  <xsd:schema xmlns:xsd="http://www.w3.org/2001/XMLSchema" xmlns:xs="http://www.w3.org/2001/XMLSchema" xmlns:p="http://schemas.microsoft.com/office/2006/metadata/properties" xmlns:ns2="78083c92-0af9-4662-99b5-5fe34061947b" xmlns:ns3="dc1a3a29-1734-4967-8cff-d351e6fc4f0c" targetNamespace="http://schemas.microsoft.com/office/2006/metadata/properties" ma:root="true" ma:fieldsID="b9c0ba933e2b573af2568ceb043f1f1b" ns2:_="" ns3:_="">
    <xsd:import namespace="78083c92-0af9-4662-99b5-5fe34061947b"/>
    <xsd:import namespace="dc1a3a29-1734-4967-8cff-d351e6fc4f0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83c92-0af9-4662-99b5-5fe34061947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3" nillable="true" ma:taxonomy="true" ma:internalName="lcf76f155ced4ddcb4097134ff3c332f" ma:taxonomyFieldName="MediaServiceImageTags" ma:displayName="Tag immagine" ma:readOnly="false" ma:fieldId="{5cf76f15-5ced-4ddc-b409-7134ff3c332f}" ma:taxonomyMulti="true" ma:sspId="e5505f8f-da62-40e5-a116-f08e7003152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c1a3a29-1734-4967-8cff-d351e6fc4f0c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e8a6735f-476e-414a-bdf7-a56c8e7d8966}" ma:internalName="TaxCatchAll" ma:showField="CatchAllData" ma:web="dc1a3a29-1734-4967-8cff-d351e6fc4f0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dc1a3a29-1734-4967-8cff-d351e6fc4f0c" xsi:nil="true"/>
    <lcf76f155ced4ddcb4097134ff3c332f xmlns="78083c92-0af9-4662-99b5-5fe34061947b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EA9C1446-F9F7-4BCA-A6B4-823C288CEA9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83c92-0af9-4662-99b5-5fe34061947b"/>
    <ds:schemaRef ds:uri="dc1a3a29-1734-4967-8cff-d351e6fc4f0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21B57CB-2989-49F3-9B3C-01B7E85A2D3A}">
  <ds:schemaRefs>
    <ds:schemaRef ds:uri="http://schemas.openxmlformats.org/package/2006/metadata/core-properties"/>
    <ds:schemaRef ds:uri="http://schemas.microsoft.com/office/2006/metadata/properties"/>
    <ds:schemaRef ds:uri="78083c92-0af9-4662-99b5-5fe34061947b"/>
    <ds:schemaRef ds:uri="http://www.w3.org/XML/1998/namespace"/>
    <ds:schemaRef ds:uri="http://schemas.microsoft.com/office/2006/documentManagement/types"/>
    <ds:schemaRef ds:uri="http://purl.org/dc/dcmitype/"/>
    <ds:schemaRef ds:uri="dc1a3a29-1734-4967-8cff-d351e6fc4f0c"/>
    <ds:schemaRef ds:uri="http://purl.org/dc/terms/"/>
    <ds:schemaRef ds:uri="http://purl.org/dc/elements/1.1/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B0C146D0-C203-4C7D-9184-64CE2F65C57C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93</Words>
  <Application>Microsoft Office PowerPoint</Application>
  <PresentationFormat>A4 (21x29,7 cm)</PresentationFormat>
  <Paragraphs>20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URA MIOZZI</dc:creator>
  <cp:lastModifiedBy>ANNA MARIA VAIRA</cp:lastModifiedBy>
  <cp:revision>5</cp:revision>
  <dcterms:created xsi:type="dcterms:W3CDTF">2024-12-17T14:13:40Z</dcterms:created>
  <dcterms:modified xsi:type="dcterms:W3CDTF">2025-02-19T18:47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3896766B253BF4C954DE14C4319FB08</vt:lpwstr>
  </property>
  <property fmtid="{D5CDD505-2E9C-101B-9397-08002B2CF9AE}" pid="3" name="MediaServiceImageTags">
    <vt:lpwstr/>
  </property>
</Properties>
</file>